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7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lara Perez Moro" userId="4500f17c-9844-4b59-9414-59df6e1f0f91" providerId="ADAL" clId="{558A9A4F-221F-4FE4-8FEB-1EAC6A07EEF5}"/>
    <pc:docChg chg="modSld">
      <pc:chgData name="Clara Perez Moro" userId="4500f17c-9844-4b59-9414-59df6e1f0f91" providerId="ADAL" clId="{558A9A4F-221F-4FE4-8FEB-1EAC6A07EEF5}" dt="2024-07-23T06:46:39.576" v="0" actId="20577"/>
      <pc:docMkLst>
        <pc:docMk/>
      </pc:docMkLst>
      <pc:sldChg chg="modSp">
        <pc:chgData name="Clara Perez Moro" userId="4500f17c-9844-4b59-9414-59df6e1f0f91" providerId="ADAL" clId="{558A9A4F-221F-4FE4-8FEB-1EAC6A07EEF5}" dt="2024-07-23T06:46:39.576" v="0" actId="20577"/>
        <pc:sldMkLst>
          <pc:docMk/>
          <pc:sldMk cId="3552844739" sldId="256"/>
        </pc:sldMkLst>
        <pc:spChg chg="mod">
          <ac:chgData name="Clara Perez Moro" userId="4500f17c-9844-4b59-9414-59df6e1f0f91" providerId="ADAL" clId="{558A9A4F-221F-4FE4-8FEB-1EAC6A07EEF5}" dt="2024-07-23T06:46:39.576" v="0" actId="20577"/>
          <ac:spMkLst>
            <pc:docMk/>
            <pc:sldMk cId="3552844739" sldId="256"/>
            <ac:spMk id="11" creationId="{C8300960-C906-02CC-C43A-3F0B0E379FAA}"/>
          </ac:spMkLst>
        </pc:spChg>
      </pc:sldChg>
    </pc:docChg>
  </pc:docChgLst>
  <pc:docChgLst>
    <pc:chgData name="Clara Perez Moro" userId="4500f17c-9844-4b59-9414-59df6e1f0f91" providerId="ADAL" clId="{0071A27F-B719-4B91-99F6-910F253C35DA}"/>
    <pc:docChg chg="modSld">
      <pc:chgData name="Clara Perez Moro" userId="4500f17c-9844-4b59-9414-59df6e1f0f91" providerId="ADAL" clId="{0071A27F-B719-4B91-99F6-910F253C35DA}" dt="2024-07-26T14:14:46.178" v="0" actId="255"/>
      <pc:docMkLst>
        <pc:docMk/>
      </pc:docMkLst>
      <pc:sldChg chg="modSp">
        <pc:chgData name="Clara Perez Moro" userId="4500f17c-9844-4b59-9414-59df6e1f0f91" providerId="ADAL" clId="{0071A27F-B719-4B91-99F6-910F253C35DA}" dt="2024-07-26T14:14:46.178" v="0" actId="255"/>
        <pc:sldMkLst>
          <pc:docMk/>
          <pc:sldMk cId="3552844739" sldId="256"/>
        </pc:sldMkLst>
        <pc:spChg chg="mod">
          <ac:chgData name="Clara Perez Moro" userId="4500f17c-9844-4b59-9414-59df6e1f0f91" providerId="ADAL" clId="{0071A27F-B719-4B91-99F6-910F253C35DA}" dt="2024-07-26T14:14:46.178" v="0" actId="255"/>
          <ac:spMkLst>
            <pc:docMk/>
            <pc:sldMk cId="3552844739" sldId="256"/>
            <ac:spMk id="11" creationId="{C8300960-C906-02CC-C43A-3F0B0E379FAA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https://upvedues-my.sharepoint.com/personal/clapemo_upv_edu_es/Documents/COPIA%20SEGURIDAD%2028%2008%202022/DOCTORADO/i176%20delhi%20cristina/bsaseq/expresion/grafica%20185%20(Recuperado)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upvedues-my.sharepoint.com/personal/clapemo_upv_edu_es/Documents/COPIA%20SEGURIDAD%2028%2008%202022/DOCTORADO/i176%20delhi%20cristina/bsaseq/expresion/grafica%20185%20(Recuperado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https://upvedues-my.sharepoint.com/personal/clapemo_upv_edu_es/Documents/COPIA%20SEGURIDAD%2028%2008%202022/DOCTORADO/i176%20delhi%20cristina/bsaseq/expresion/grafica%20185%20(Recuperado)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https://upvedues-my.sharepoint.com/personal/clapemo_upv_edu_es/Documents/COPIA%20SEGURIDAD%2028%2008%202022/DOCTORADO/i176%20delhi%20cristina/bsaseq/expresion/grafica%20185%20(Recuperado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108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MELO3C017283.2</a:t>
            </a:r>
          </a:p>
          <a:p>
            <a:pPr algn="ctr" rtl="0">
              <a:defRPr/>
            </a:pPr>
            <a:r>
              <a:rPr lang="en-US"/>
              <a:t>Transmembrane protein, putativ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sz="108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grafica%20185 (Recuperado).xlsx]283'!$K$8</c:f>
              <c:strCache>
                <c:ptCount val="1"/>
                <c:pt idx="0">
                  <c:v>PSm</c:v>
                </c:pt>
              </c:strCache>
            </c:strRef>
          </c:tx>
          <c:spPr>
            <a:solidFill>
              <a:srgbClr val="9DC3E6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3.7037037037037125E-2"/>
                </c:manualLayout>
              </c:layout>
              <c:tx>
                <c:rich>
                  <a:bodyPr/>
                  <a:lstStyle/>
                  <a:p>
                    <a:fld id="{6C3FE031-52FE-44F5-AEF7-0EC1C7EA3717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0-08D8-49B3-9C9D-DA35390E4C82}"/>
                </c:ext>
              </c:extLst>
            </c:dLbl>
            <c:dLbl>
              <c:idx val="1"/>
              <c:layout>
                <c:manualLayout>
                  <c:x val="0"/>
                  <c:y val="-3.7159533998962019E-2"/>
                </c:manualLayout>
              </c:layout>
              <c:tx>
                <c:rich>
                  <a:bodyPr/>
                  <a:lstStyle/>
                  <a:p>
                    <a:fld id="{DD9524F4-1715-4805-A759-B6CF4E724B9F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08D8-49B3-9C9D-DA35390E4C82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6AE9746C-7B6A-479F-910B-9A17B3E60BA7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2-08D8-49B3-9C9D-DA35390E4C82}"/>
                </c:ext>
              </c:extLst>
            </c:dLbl>
            <c:dLbl>
              <c:idx val="3"/>
              <c:layout>
                <c:manualLayout>
                  <c:x val="0"/>
                  <c:y val="-1.3934825249610842E-2"/>
                </c:manualLayout>
              </c:layout>
              <c:tx>
                <c:rich>
                  <a:bodyPr/>
                  <a:lstStyle/>
                  <a:p>
                    <a:fld id="{4BA6361E-8D1A-499F-82B8-524C8A1DBAC6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3-08D8-49B3-9C9D-DA35390E4C82}"/>
                </c:ext>
              </c:extLst>
            </c:dLbl>
            <c:dLbl>
              <c:idx val="4"/>
              <c:layout>
                <c:manualLayout>
                  <c:x val="0"/>
                  <c:y val="-5.5739300998443118E-2"/>
                </c:manualLayout>
              </c:layout>
              <c:tx>
                <c:rich>
                  <a:bodyPr/>
                  <a:lstStyle/>
                  <a:p>
                    <a:fld id="{8DCEF109-6A45-4094-811A-D19B0AF094AB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08D8-49B3-9C9D-DA35390E4C82}"/>
                </c:ext>
              </c:extLst>
            </c:dLbl>
            <c:dLbl>
              <c:idx val="5"/>
              <c:layout>
                <c:manualLayout>
                  <c:x val="0"/>
                  <c:y val="-5.1094359248572779E-2"/>
                </c:manualLayout>
              </c:layout>
              <c:tx>
                <c:rich>
                  <a:bodyPr/>
                  <a:lstStyle/>
                  <a:p>
                    <a:fld id="{56A2C18F-31D4-45A4-9841-58691AEE0462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08D8-49B3-9C9D-DA35390E4C8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en-US"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grafica%20185 (Recuperado).xlsx]283'!$K$10,'[grafica%20185 (Recuperado).xlsx]283'!$O$10,'[grafica%20185 (Recuperado).xlsx]283'!$S$10,'[grafica%20185 (Recuperado).xlsx]283'!$W$10,'[grafica%20185 (Recuperado).xlsx]283'!$AA$10,'[grafica%20185 (Recuperado).xlsx]283'!$AE$10</c:f>
                <c:numCache>
                  <c:formatCode>General</c:formatCode>
                  <c:ptCount val="6"/>
                  <c:pt idx="0">
                    <c:v>1.6414977119056096</c:v>
                  </c:pt>
                  <c:pt idx="1">
                    <c:v>3.9481898447463686</c:v>
                  </c:pt>
                  <c:pt idx="2">
                    <c:v>2.0593617461369638</c:v>
                  </c:pt>
                  <c:pt idx="3">
                    <c:v>2.8129763938088943</c:v>
                  </c:pt>
                  <c:pt idx="4">
                    <c:v>6.2236677773698794</c:v>
                  </c:pt>
                  <c:pt idx="5">
                    <c:v>5.7742264931071707</c:v>
                  </c:pt>
                </c:numCache>
              </c:numRef>
            </c:plus>
            <c:minus>
              <c:numRef>
                <c:f>'[grafica%20185 (Recuperado).xlsx]283'!$K$10,'[grafica%20185 (Recuperado).xlsx]283'!$O$10,'[grafica%20185 (Recuperado).xlsx]283'!$S$10,'[grafica%20185 (Recuperado).xlsx]283'!$W$10,'[grafica%20185 (Recuperado).xlsx]283'!$AA$10,'[grafica%20185 (Recuperado).xlsx]283'!$AE$10</c:f>
                <c:numCache>
                  <c:formatCode>General</c:formatCode>
                  <c:ptCount val="6"/>
                  <c:pt idx="0">
                    <c:v>1.6414977119056096</c:v>
                  </c:pt>
                  <c:pt idx="1">
                    <c:v>3.9481898447463686</c:v>
                  </c:pt>
                  <c:pt idx="2">
                    <c:v>2.0593617461369638</c:v>
                  </c:pt>
                  <c:pt idx="3">
                    <c:v>2.8129763938088943</c:v>
                  </c:pt>
                  <c:pt idx="4">
                    <c:v>6.2236677773698794</c:v>
                  </c:pt>
                  <c:pt idx="5">
                    <c:v>5.77422649310717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grafica%20185 (Recuperado).xlsx]283'!$K$12:$K$17</c:f>
              <c:numCache>
                <c:formatCode>General</c:formatCode>
                <c:ptCount val="6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5</c:v>
                </c:pt>
                <c:pt idx="4">
                  <c:v>21</c:v>
                </c:pt>
                <c:pt idx="5">
                  <c:v>30</c:v>
                </c:pt>
              </c:numCache>
            </c:numRef>
          </c:cat>
          <c:val>
            <c:numRef>
              <c:f>'[grafica%20185 (Recuperado).xlsx]283'!$K$9,'[grafica%20185 (Recuperado).xlsx]283'!$O$9,'[grafica%20185 (Recuperado).xlsx]283'!$S$9,'[grafica%20185 (Recuperado).xlsx]283'!$W$9,'[grafica%20185 (Recuperado).xlsx]283'!$AA$9,'[grafica%20185 (Recuperado).xlsx]283'!$AE$9</c:f>
              <c:numCache>
                <c:formatCode>General</c:formatCode>
                <c:ptCount val="6"/>
                <c:pt idx="0">
                  <c:v>4.2351768212076326</c:v>
                </c:pt>
                <c:pt idx="1">
                  <c:v>6.6501237307715213</c:v>
                </c:pt>
                <c:pt idx="2">
                  <c:v>5.8304998898099223</c:v>
                </c:pt>
                <c:pt idx="3">
                  <c:v>8.679680220259117</c:v>
                </c:pt>
                <c:pt idx="4">
                  <c:v>7.8050013681900161</c:v>
                </c:pt>
                <c:pt idx="5">
                  <c:v>7.0891345351220849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grafica%20185 (Recuperado).xlsx]283'!$S$12:$X$12</c15:f>
                <c15:dlblRangeCache>
                  <c:ptCount val="6"/>
                  <c:pt idx="0">
                    <c:v>ab</c:v>
                  </c:pt>
                  <c:pt idx="1">
                    <c:v>a</c:v>
                  </c:pt>
                  <c:pt idx="2">
                    <c:v>ab</c:v>
                  </c:pt>
                  <c:pt idx="3">
                    <c:v>a</c:v>
                  </c:pt>
                  <c:pt idx="4">
                    <c:v>a</c:v>
                  </c:pt>
                  <c:pt idx="5">
                    <c:v>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6-08D8-49B3-9C9D-DA35390E4C82}"/>
            </c:ext>
          </c:extLst>
        </c:ser>
        <c:ser>
          <c:idx val="1"/>
          <c:order val="1"/>
          <c:tx>
            <c:strRef>
              <c:f>'[grafica%20185 (Recuperado).xlsx]283'!$L$8</c:f>
              <c:strCache>
                <c:ptCount val="1"/>
                <c:pt idx="0">
                  <c:v>PSi</c:v>
                </c:pt>
              </c:strCache>
            </c:strRef>
          </c:tx>
          <c:spPr>
            <a:solidFill>
              <a:srgbClr val="4472C4"/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fld id="{9C97FDA2-C50D-45B6-8B0C-10AF3A12F44E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7-08D8-49B3-9C9D-DA35390E4C82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8D56D1BF-87C6-4442-9C6F-AB36589CFF71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8-08D8-49B3-9C9D-DA35390E4C82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6AC1AC52-EB7A-465F-B6B6-48A944307341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9-08D8-49B3-9C9D-DA35390E4C82}"/>
                </c:ext>
              </c:extLst>
            </c:dLbl>
            <c:dLbl>
              <c:idx val="3"/>
              <c:layout>
                <c:manualLayout>
                  <c:x val="-1.0177016286715852E-16"/>
                  <c:y val="-5.1094359248572779E-2"/>
                </c:manualLayout>
              </c:layout>
              <c:tx>
                <c:rich>
                  <a:bodyPr/>
                  <a:lstStyle/>
                  <a:p>
                    <a:fld id="{6290E27C-BFDB-4343-BF1F-AB659F6D9ADC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A-08D8-49B3-9C9D-DA35390E4C82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BDB412FB-5F39-457D-9039-F5F1F399C501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B-08D8-49B3-9C9D-DA35390E4C82}"/>
                </c:ext>
              </c:extLst>
            </c:dLbl>
            <c:dLbl>
              <c:idx val="5"/>
              <c:layout>
                <c:manualLayout>
                  <c:x val="0"/>
                  <c:y val="-0.16257296124545889"/>
                </c:manualLayout>
              </c:layout>
              <c:tx>
                <c:rich>
                  <a:bodyPr/>
                  <a:lstStyle/>
                  <a:p>
                    <a:fld id="{B63B5B1E-572E-4167-98A2-BBF171FA624D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C-08D8-49B3-9C9D-DA35390E4C8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en-US"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grafica%20185 (Recuperado).xlsx]283'!$L$10,'[grafica%20185 (Recuperado).xlsx]283'!$P$10,'[grafica%20185 (Recuperado).xlsx]283'!$T$10,'[grafica%20185 (Recuperado).xlsx]283'!$X$10,'[grafica%20185 (Recuperado).xlsx]283'!$AB$10,'[grafica%20185 (Recuperado).xlsx]283'!$AF$10</c:f>
                <c:numCache>
                  <c:formatCode>General</c:formatCode>
                  <c:ptCount val="6"/>
                  <c:pt idx="0">
                    <c:v>1.9628870173282955</c:v>
                  </c:pt>
                  <c:pt idx="1">
                    <c:v>1.970620766082559</c:v>
                  </c:pt>
                  <c:pt idx="2">
                    <c:v>0.11440862625305213</c:v>
                  </c:pt>
                  <c:pt idx="3">
                    <c:v>5.4501353787702458</c:v>
                  </c:pt>
                  <c:pt idx="4">
                    <c:v>0.68204087602620589</c:v>
                  </c:pt>
                  <c:pt idx="5">
                    <c:v>13.039546477303109</c:v>
                  </c:pt>
                </c:numCache>
              </c:numRef>
            </c:plus>
            <c:minus>
              <c:numRef>
                <c:f>'[grafica%20185 (Recuperado).xlsx]283'!$L$10,'[grafica%20185 (Recuperado).xlsx]283'!$P$10,'[grafica%20185 (Recuperado).xlsx]283'!$T$10,'[grafica%20185 (Recuperado).xlsx]283'!$X$10,'[grafica%20185 (Recuperado).xlsx]283'!$AB$10,'[grafica%20185 (Recuperado).xlsx]283'!$AF$10</c:f>
                <c:numCache>
                  <c:formatCode>General</c:formatCode>
                  <c:ptCount val="6"/>
                  <c:pt idx="0">
                    <c:v>1.9628870173282955</c:v>
                  </c:pt>
                  <c:pt idx="1">
                    <c:v>1.970620766082559</c:v>
                  </c:pt>
                  <c:pt idx="2">
                    <c:v>0.11440862625305213</c:v>
                  </c:pt>
                  <c:pt idx="3">
                    <c:v>5.4501353787702458</c:v>
                  </c:pt>
                  <c:pt idx="4">
                    <c:v>0.68204087602620589</c:v>
                  </c:pt>
                  <c:pt idx="5">
                    <c:v>13.0395464773031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grafica%20185 (Recuperado).xlsx]283'!$L$9,'[grafica%20185 (Recuperado).xlsx]283'!$P$9,'[grafica%20185 (Recuperado).xlsx]283'!$T$9,'[grafica%20185 (Recuperado).xlsx]283'!$X$9,'[grafica%20185 (Recuperado).xlsx]283'!$AB$9,'[grafica%20185 (Recuperado).xlsx]283'!$AF$9</c:f>
              <c:numCache>
                <c:formatCode>General</c:formatCode>
                <c:ptCount val="6"/>
                <c:pt idx="0">
                  <c:v>5.8976525398942519</c:v>
                </c:pt>
                <c:pt idx="1">
                  <c:v>3.4522697265423901</c:v>
                </c:pt>
                <c:pt idx="2">
                  <c:v>9.4322773180007271</c:v>
                </c:pt>
                <c:pt idx="3">
                  <c:v>9.4941521870832215</c:v>
                </c:pt>
                <c:pt idx="4">
                  <c:v>3.6382896560197673</c:v>
                </c:pt>
                <c:pt idx="5">
                  <c:v>24.318873908945708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grafica%20185 (Recuperado).xlsx]283'!$S$13:$X$13</c15:f>
                <c15:dlblRangeCache>
                  <c:ptCount val="6"/>
                  <c:pt idx="0">
                    <c:v>a</c:v>
                  </c:pt>
                  <c:pt idx="1">
                    <c:v>a</c:v>
                  </c:pt>
                  <c:pt idx="2">
                    <c:v>a</c:v>
                  </c:pt>
                  <c:pt idx="3">
                    <c:v>a</c:v>
                  </c:pt>
                  <c:pt idx="4">
                    <c:v>a</c:v>
                  </c:pt>
                  <c:pt idx="5">
                    <c:v>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D-08D8-49B3-9C9D-DA35390E4C82}"/>
            </c:ext>
          </c:extLst>
        </c:ser>
        <c:ser>
          <c:idx val="2"/>
          <c:order val="2"/>
          <c:tx>
            <c:strRef>
              <c:f>'[grafica%20185 (Recuperado).xlsx]283'!$M$8</c:f>
              <c:strCache>
                <c:ptCount val="1"/>
                <c:pt idx="0">
                  <c:v>PI 414723i</c:v>
                </c:pt>
              </c:strCache>
            </c:strRef>
          </c:tx>
          <c:spPr>
            <a:solidFill>
              <a:srgbClr val="F4B183"/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fld id="{A7DFC09C-16BD-4C1E-8045-C9BB69CCB255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E-08D8-49B3-9C9D-DA35390E4C82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507CB0CF-3C50-4C0D-9F75-5B0B3A9563E5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F-08D8-49B3-9C9D-DA35390E4C82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C29153FD-63A6-44F2-B150-11814B2161A4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0-08D8-49B3-9C9D-DA35390E4C82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75A50A71-4AAB-4DC3-9AA6-BF0BDE05E064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1-08D8-49B3-9C9D-DA35390E4C82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69F7A461-9465-4AE6-BF13-193110C0F7F1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2-08D8-49B3-9C9D-DA35390E4C82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62DA6D91-732F-4947-AC81-503F0490A0C5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3-08D8-49B3-9C9D-DA35390E4C8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en-US"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grafica%20185 (Recuperado).xlsx]283'!$M$10,'[grafica%20185 (Recuperado).xlsx]283'!$Q$10,'[grafica%20185 (Recuperado).xlsx]283'!$U$10,'[grafica%20185 (Recuperado).xlsx]283'!$Y$10,'[grafica%20185 (Recuperado).xlsx]283'!$AC$10,'[grafica%20185 (Recuperado).xlsx]283'!$AG$10</c:f>
                <c:numCache>
                  <c:formatCode>General</c:formatCode>
                  <c:ptCount val="6"/>
                  <c:pt idx="0">
                    <c:v>0.3203741860401903</c:v>
                  </c:pt>
                  <c:pt idx="1">
                    <c:v>0.9223836257621203</c:v>
                  </c:pt>
                  <c:pt idx="2">
                    <c:v>0.33218854462182429</c:v>
                  </c:pt>
                  <c:pt idx="3">
                    <c:v>0.92416469334518014</c:v>
                  </c:pt>
                  <c:pt idx="4">
                    <c:v>0.60444511389741362</c:v>
                  </c:pt>
                  <c:pt idx="5">
                    <c:v>0.81729204876423622</c:v>
                  </c:pt>
                </c:numCache>
              </c:numRef>
            </c:plus>
            <c:minus>
              <c:numRef>
                <c:f>'[grafica%20185 (Recuperado).xlsx]283'!$M$10,'[grafica%20185 (Recuperado).xlsx]283'!$Q$10,'[grafica%20185 (Recuperado).xlsx]283'!$U$10,'[grafica%20185 (Recuperado).xlsx]283'!$Y$10,'[grafica%20185 (Recuperado).xlsx]283'!$AC$10,'[grafica%20185 (Recuperado).xlsx]283'!$AG$10</c:f>
                <c:numCache>
                  <c:formatCode>General</c:formatCode>
                  <c:ptCount val="6"/>
                  <c:pt idx="0">
                    <c:v>0.3203741860401903</c:v>
                  </c:pt>
                  <c:pt idx="1">
                    <c:v>0.9223836257621203</c:v>
                  </c:pt>
                  <c:pt idx="2">
                    <c:v>0.33218854462182429</c:v>
                  </c:pt>
                  <c:pt idx="3">
                    <c:v>0.92416469334518014</c:v>
                  </c:pt>
                  <c:pt idx="4">
                    <c:v>0.60444511389741362</c:v>
                  </c:pt>
                  <c:pt idx="5">
                    <c:v>0.817292048764236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grafica%20185 (Recuperado).xlsx]283'!$M$9,'[grafica%20185 (Recuperado).xlsx]283'!$Q$9,'[grafica%20185 (Recuperado).xlsx]283'!$U$9,'[grafica%20185 (Recuperado).xlsx]283'!$Y$9,'[grafica%20185 (Recuperado).xlsx]283'!$AC$9,'[grafica%20185 (Recuperado).xlsx]283'!$AG$9</c:f>
              <c:numCache>
                <c:formatCode>General</c:formatCode>
                <c:ptCount val="6"/>
                <c:pt idx="0">
                  <c:v>2.2491847706316093</c:v>
                </c:pt>
                <c:pt idx="1">
                  <c:v>3.1153389043143984</c:v>
                </c:pt>
                <c:pt idx="2">
                  <c:v>2.1472268552561458</c:v>
                </c:pt>
                <c:pt idx="3">
                  <c:v>3.6094841677559288</c:v>
                </c:pt>
                <c:pt idx="4">
                  <c:v>2.9012460252504439</c:v>
                </c:pt>
                <c:pt idx="5">
                  <c:v>4.7595214606174991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grafica%20185 (Recuperado).xlsx]283'!$S$14:$X$14</c15:f>
                <c15:dlblRangeCache>
                  <c:ptCount val="6"/>
                  <c:pt idx="0">
                    <c:v>ab</c:v>
                  </c:pt>
                  <c:pt idx="1">
                    <c:v>a</c:v>
                  </c:pt>
                  <c:pt idx="2">
                    <c:v>ab</c:v>
                  </c:pt>
                  <c:pt idx="3">
                    <c:v>a</c:v>
                  </c:pt>
                  <c:pt idx="4">
                    <c:v>a</c:v>
                  </c:pt>
                  <c:pt idx="5">
                    <c:v>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14-08D8-49B3-9C9D-DA35390E4C82}"/>
            </c:ext>
          </c:extLst>
        </c:ser>
        <c:ser>
          <c:idx val="3"/>
          <c:order val="3"/>
          <c:tx>
            <c:strRef>
              <c:f>'[grafica%20185 (Recuperado).xlsx]283'!$N$8</c:f>
              <c:strCache>
                <c:ptCount val="1"/>
                <c:pt idx="0">
                  <c:v>PI414723m</c:v>
                </c:pt>
              </c:strCache>
            </c:strRef>
          </c:tx>
          <c:spPr>
            <a:solidFill>
              <a:srgbClr val="ED7D31"/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fld id="{D48807AE-F26F-481B-8321-9BD7D7352CB7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5-08D8-49B3-9C9D-DA35390E4C82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65FF2EDF-6CAD-4587-82CC-7D4F3DF2381D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6-08D8-49B3-9C9D-DA35390E4C82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1837900B-5349-44BE-9A91-0E22A4C181E7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7-08D8-49B3-9C9D-DA35390E4C82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56E72FA3-B986-413D-BEBE-1655262E2CE1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8-08D8-49B3-9C9D-DA35390E4C82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FDE6CEC1-2BAA-4583-855E-B673ED084E8B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9-08D8-49B3-9C9D-DA35390E4C82}"/>
                </c:ext>
              </c:extLst>
            </c:dLbl>
            <c:dLbl>
              <c:idx val="5"/>
              <c:layout>
                <c:manualLayout>
                  <c:x val="-1.0177016286715852E-16"/>
                  <c:y val="-0.15328307774571834"/>
                </c:manualLayout>
              </c:layout>
              <c:tx>
                <c:rich>
                  <a:bodyPr/>
                  <a:lstStyle/>
                  <a:p>
                    <a:fld id="{4F9EB5BC-D9AE-41F0-AEBC-128D29D31C03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A-08D8-49B3-9C9D-DA35390E4C8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en-US"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grafica%20185 (Recuperado).xlsx]283'!$N$10,'[grafica%20185 (Recuperado).xlsx]283'!$R$10,'[grafica%20185 (Recuperado).xlsx]283'!$V$10,'[grafica%20185 (Recuperado).xlsx]283'!$Z$10,'[grafica%20185 (Recuperado).xlsx]283'!$AD$10,'[grafica%20185 (Recuperado).xlsx]283'!$AH$10</c:f>
                <c:numCache>
                  <c:formatCode>General</c:formatCode>
                  <c:ptCount val="6"/>
                  <c:pt idx="0">
                    <c:v>0.50122721155811789</c:v>
                  </c:pt>
                  <c:pt idx="1">
                    <c:v>1.8323145350816441</c:v>
                  </c:pt>
                  <c:pt idx="2">
                    <c:v>1.9104610153304706</c:v>
                  </c:pt>
                  <c:pt idx="3">
                    <c:v>1.0590736436934312</c:v>
                  </c:pt>
                  <c:pt idx="4">
                    <c:v>0.6432478775720204</c:v>
                  </c:pt>
                  <c:pt idx="5">
                    <c:v>12.247218181559088</c:v>
                  </c:pt>
                </c:numCache>
              </c:numRef>
            </c:plus>
            <c:minus>
              <c:numRef>
                <c:f>'[grafica%20185 (Recuperado).xlsx]283'!$N$10,'[grafica%20185 (Recuperado).xlsx]283'!$R$10,'[grafica%20185 (Recuperado).xlsx]283'!$V$10,'[grafica%20185 (Recuperado).xlsx]283'!$Z$10,'[grafica%20185 (Recuperado).xlsx]283'!$AD$10,'[grafica%20185 (Recuperado).xlsx]283'!$AH$10</c:f>
                <c:numCache>
                  <c:formatCode>General</c:formatCode>
                  <c:ptCount val="6"/>
                  <c:pt idx="0">
                    <c:v>0.50122721155811789</c:v>
                  </c:pt>
                  <c:pt idx="1">
                    <c:v>1.8323145350816441</c:v>
                  </c:pt>
                  <c:pt idx="2">
                    <c:v>1.9104610153304706</c:v>
                  </c:pt>
                  <c:pt idx="3">
                    <c:v>1.0590736436934312</c:v>
                  </c:pt>
                  <c:pt idx="4">
                    <c:v>0.6432478775720204</c:v>
                  </c:pt>
                  <c:pt idx="5">
                    <c:v>12.2472181815590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grafica%20185 (Recuperado).xlsx]283'!$N$9,'[grafica%20185 (Recuperado).xlsx]283'!$R$9,'[grafica%20185 (Recuperado).xlsx]283'!$V$9,'[grafica%20185 (Recuperado).xlsx]283'!$Z$9,'[grafica%20185 (Recuperado).xlsx]283'!$AD$9,'[grafica%20185 (Recuperado).xlsx]283'!$AH$9</c:f>
              <c:numCache>
                <c:formatCode>General</c:formatCode>
                <c:ptCount val="6"/>
                <c:pt idx="0">
                  <c:v>1.7294678493399465</c:v>
                </c:pt>
                <c:pt idx="1">
                  <c:v>7.4392766086154545</c:v>
                </c:pt>
                <c:pt idx="2">
                  <c:v>5.5279785255748228</c:v>
                </c:pt>
                <c:pt idx="3">
                  <c:v>4.1977866666059933</c:v>
                </c:pt>
                <c:pt idx="4">
                  <c:v>3.7491233775761739</c:v>
                </c:pt>
                <c:pt idx="5">
                  <c:v>18.868490954775151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grafica%20185 (Recuperado).xlsx]283'!$S$15:$X$15</c15:f>
                <c15:dlblRangeCache>
                  <c:ptCount val="6"/>
                  <c:pt idx="0">
                    <c:v>b</c:v>
                  </c:pt>
                  <c:pt idx="1">
                    <c:v>a</c:v>
                  </c:pt>
                  <c:pt idx="2">
                    <c:v>b</c:v>
                  </c:pt>
                  <c:pt idx="3">
                    <c:v>a</c:v>
                  </c:pt>
                  <c:pt idx="4">
                    <c:v>a</c:v>
                  </c:pt>
                  <c:pt idx="5">
                    <c:v>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1B-08D8-49B3-9C9D-DA35390E4C82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647053295"/>
        <c:axId val="647046095"/>
      </c:barChart>
      <c:catAx>
        <c:axId val="6470532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647046095"/>
        <c:crosses val="autoZero"/>
        <c:auto val="1"/>
        <c:lblAlgn val="ctr"/>
        <c:lblOffset val="100"/>
        <c:noMultiLvlLbl val="0"/>
      </c:catAx>
      <c:valAx>
        <c:axId val="647046095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64705329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lang="en-US" sz="900" b="0" i="0" u="none" strike="noStrike" kern="1200" baseline="0">
          <a:solidFill>
            <a:schemeClr val="tx1"/>
          </a:solidFill>
          <a:latin typeface="+mn-lt"/>
          <a:ea typeface="+mn-ea"/>
          <a:cs typeface="+mn-cs"/>
        </a:defRPr>
      </a:pPr>
      <a:endParaRPr lang="es-E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108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s-ES"/>
              <a:t>MELO3C017185.2</a:t>
            </a:r>
          </a:p>
          <a:p>
            <a:pPr algn="ctr" rtl="0">
              <a:defRPr/>
            </a:pPr>
            <a:r>
              <a:rPr lang="es-ES"/>
              <a:t>NAC domain protein</a:t>
            </a:r>
            <a:endParaRPr lang="en-GB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sz="108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grafica%20185 (Recuperado).xlsx]185'!$A$1</c:f>
              <c:strCache>
                <c:ptCount val="1"/>
                <c:pt idx="0">
                  <c:v>PSm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40000"/>
                  <a:lumOff val="60000"/>
                </a:schemeClr>
              </a:solidFill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fld id="{33EA7EDE-45C5-4F10-9D3A-7A88922D462F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0-9EE1-48B3-BDD1-FA2DEE634066}"/>
                </c:ext>
              </c:extLst>
            </c:dLbl>
            <c:dLbl>
              <c:idx val="1"/>
              <c:layout>
                <c:manualLayout>
                  <c:x val="-5.0925337632079971E-17"/>
                  <c:y val="-2.7777777777777863E-2"/>
                </c:manualLayout>
              </c:layout>
              <c:tx>
                <c:rich>
                  <a:bodyPr/>
                  <a:lstStyle/>
                  <a:p>
                    <a:fld id="{D98C84E3-DB79-4C67-9D95-7615C3CF708A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9EE1-48B3-BDD1-FA2DEE634066}"/>
                </c:ext>
              </c:extLst>
            </c:dLbl>
            <c:dLbl>
              <c:idx val="2"/>
              <c:layout>
                <c:manualLayout>
                  <c:x val="-2.7777777777777779E-3"/>
                  <c:y val="-5.5555555555555552E-2"/>
                </c:manualLayout>
              </c:layout>
              <c:tx>
                <c:rich>
                  <a:bodyPr/>
                  <a:lstStyle/>
                  <a:p>
                    <a:fld id="{E2744AA8-4D66-4ABE-9C21-05426D837867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2-9EE1-48B3-BDD1-FA2DEE634066}"/>
                </c:ext>
              </c:extLst>
            </c:dLbl>
            <c:dLbl>
              <c:idx val="3"/>
              <c:layout>
                <c:manualLayout>
                  <c:x val="0"/>
                  <c:y val="-5.5555555555555643E-2"/>
                </c:manualLayout>
              </c:layout>
              <c:tx>
                <c:rich>
                  <a:bodyPr/>
                  <a:lstStyle/>
                  <a:p>
                    <a:fld id="{9EF2FA90-1375-4949-BF6F-BF77B1015E91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3-9EE1-48B3-BDD1-FA2DEE634066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9BD44CCB-3EB9-48D1-8672-F576EFA627B5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4-9EE1-48B3-BDD1-FA2DEE634066}"/>
                </c:ext>
              </c:extLst>
            </c:dLbl>
            <c:dLbl>
              <c:idx val="5"/>
              <c:layout>
                <c:manualLayout>
                  <c:x val="-2.7777777777777779E-3"/>
                  <c:y val="-4.1666666666666755E-2"/>
                </c:manualLayout>
              </c:layout>
              <c:tx>
                <c:rich>
                  <a:bodyPr/>
                  <a:lstStyle/>
                  <a:p>
                    <a:fld id="{B4BA3922-8ACB-46F5-A22D-8ADDDD2C5F85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9EE1-48B3-BDD1-FA2DEE63406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en-US"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grafica%20185 (Recuperado).xlsx]185'!$C$13:$H$13</c:f>
                <c:numCache>
                  <c:formatCode>General</c:formatCode>
                  <c:ptCount val="6"/>
                  <c:pt idx="0">
                    <c:v>0.15174739099999998</c:v>
                  </c:pt>
                  <c:pt idx="1">
                    <c:v>3.1852613598619577</c:v>
                  </c:pt>
                  <c:pt idx="2">
                    <c:v>4.8612025754848052</c:v>
                  </c:pt>
                  <c:pt idx="3">
                    <c:v>5.1517094302212838</c:v>
                  </c:pt>
                  <c:pt idx="4">
                    <c:v>2.1146876433517927</c:v>
                  </c:pt>
                  <c:pt idx="5">
                    <c:v>5.5371027208767982</c:v>
                  </c:pt>
                </c:numCache>
              </c:numRef>
            </c:plus>
            <c:minus>
              <c:numRef>
                <c:f>'[grafica%20185 (Recuperado).xlsx]185'!$C$13:$H$13</c:f>
                <c:numCache>
                  <c:formatCode>General</c:formatCode>
                  <c:ptCount val="6"/>
                  <c:pt idx="0">
                    <c:v>0.15174739099999998</c:v>
                  </c:pt>
                  <c:pt idx="1">
                    <c:v>3.1852613598619577</c:v>
                  </c:pt>
                  <c:pt idx="2">
                    <c:v>4.8612025754848052</c:v>
                  </c:pt>
                  <c:pt idx="3">
                    <c:v>5.1517094302212838</c:v>
                  </c:pt>
                  <c:pt idx="4">
                    <c:v>2.1146876433517927</c:v>
                  </c:pt>
                  <c:pt idx="5">
                    <c:v>5.53710272087679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grafica%20185 (Recuperado).xlsx]185'!$A$9:$A$14</c:f>
              <c:numCache>
                <c:formatCode>General</c:formatCode>
                <c:ptCount val="6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5</c:v>
                </c:pt>
                <c:pt idx="4">
                  <c:v>21</c:v>
                </c:pt>
                <c:pt idx="5">
                  <c:v>30</c:v>
                </c:pt>
              </c:numCache>
            </c:numRef>
          </c:cat>
          <c:val>
            <c:numRef>
              <c:f>'[grafica%20185 (Recuperado).xlsx]185'!$A$7,'[grafica%20185 (Recuperado).xlsx]185'!$E$7,'[grafica%20185 (Recuperado).xlsx]185'!$I$7,'[grafica%20185 (Recuperado).xlsx]185'!$M$7,'[grafica%20185 (Recuperado).xlsx]185'!$Q$7,'[grafica%20185 (Recuperado).xlsx]185'!$U$7</c:f>
              <c:numCache>
                <c:formatCode>General</c:formatCode>
                <c:ptCount val="6"/>
                <c:pt idx="0">
                  <c:v>0.18767268600000001</c:v>
                </c:pt>
                <c:pt idx="1">
                  <c:v>11.139433762666668</c:v>
                </c:pt>
                <c:pt idx="2">
                  <c:v>10.281128781333335</c:v>
                </c:pt>
                <c:pt idx="3">
                  <c:v>9.8865923843333334</c:v>
                </c:pt>
                <c:pt idx="4">
                  <c:v>2.7182013166666668</c:v>
                </c:pt>
                <c:pt idx="5">
                  <c:v>7.0159918153333338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grafica%20185 (Recuperado).xlsx]185'!$C$17:$H$17</c15:f>
                <c15:dlblRangeCache>
                  <c:ptCount val="6"/>
                  <c:pt idx="0">
                    <c:v>a</c:v>
                  </c:pt>
                  <c:pt idx="1">
                    <c:v>a</c:v>
                  </c:pt>
                  <c:pt idx="2">
                    <c:v>a</c:v>
                  </c:pt>
                  <c:pt idx="3">
                    <c:v>a</c:v>
                  </c:pt>
                  <c:pt idx="4">
                    <c:v>a</c:v>
                  </c:pt>
                  <c:pt idx="5">
                    <c:v>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6-9EE1-48B3-BDD1-FA2DEE634066}"/>
            </c:ext>
          </c:extLst>
        </c:ser>
        <c:ser>
          <c:idx val="1"/>
          <c:order val="1"/>
          <c:tx>
            <c:strRef>
              <c:f>'[grafica%20185 (Recuperado).xlsx]185'!$B$1</c:f>
              <c:strCache>
                <c:ptCount val="1"/>
                <c:pt idx="0">
                  <c:v>PSi</c:v>
                </c:pt>
              </c:strCache>
            </c:strRef>
          </c:tx>
          <c:spPr>
            <a:solidFill>
              <a:schemeClr val="accent5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fld id="{215C5244-E737-4F6F-9FCB-848132D9C978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7-9EE1-48B3-BDD1-FA2DEE634066}"/>
                </c:ext>
              </c:extLst>
            </c:dLbl>
            <c:dLbl>
              <c:idx val="1"/>
              <c:layout>
                <c:manualLayout>
                  <c:x val="0"/>
                  <c:y val="-4.6296296296296294E-2"/>
                </c:manualLayout>
              </c:layout>
              <c:tx>
                <c:rich>
                  <a:bodyPr/>
                  <a:lstStyle/>
                  <a:p>
                    <a:fld id="{A3BC1BF5-F2E6-4072-B71D-4C86F995585A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8-9EE1-48B3-BDD1-FA2DEE634066}"/>
                </c:ext>
              </c:extLst>
            </c:dLbl>
            <c:dLbl>
              <c:idx val="2"/>
              <c:layout>
                <c:manualLayout>
                  <c:x val="-5.5555555555555558E-3"/>
                  <c:y val="-0.17129629629629628"/>
                </c:manualLayout>
              </c:layout>
              <c:tx>
                <c:rich>
                  <a:bodyPr/>
                  <a:lstStyle/>
                  <a:p>
                    <a:fld id="{A2CCBDEA-1486-41FB-81EF-9C0DFD3C5C42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9-9EE1-48B3-BDD1-FA2DEE634066}"/>
                </c:ext>
              </c:extLst>
            </c:dLbl>
            <c:dLbl>
              <c:idx val="3"/>
              <c:layout>
                <c:manualLayout>
                  <c:x val="0"/>
                  <c:y val="-4.6296296296296294E-2"/>
                </c:manualLayout>
              </c:layout>
              <c:tx>
                <c:rich>
                  <a:bodyPr/>
                  <a:lstStyle/>
                  <a:p>
                    <a:fld id="{8B5E69B4-E1E8-4C7C-BA1C-C98B1120A1A3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A-9EE1-48B3-BDD1-FA2DEE634066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4DA65BF3-DBE8-4D65-80BC-700506A394B3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B-9EE1-48B3-BDD1-FA2DEE634066}"/>
                </c:ext>
              </c:extLst>
            </c:dLbl>
            <c:dLbl>
              <c:idx val="5"/>
              <c:layout>
                <c:manualLayout>
                  <c:x val="-2.0370135052831988E-16"/>
                  <c:y val="-7.8703703703703706E-2"/>
                </c:manualLayout>
              </c:layout>
              <c:tx>
                <c:rich>
                  <a:bodyPr/>
                  <a:lstStyle/>
                  <a:p>
                    <a:fld id="{96D92A7B-EFBD-46C0-A85C-356BB2B56655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C-9EE1-48B3-BDD1-FA2DEE63406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en-US"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grafica%20185 (Recuperado).xlsx]185'!$C$14:$H$14</c:f>
                <c:numCache>
                  <c:formatCode>General</c:formatCode>
                  <c:ptCount val="6"/>
                  <c:pt idx="0">
                    <c:v>5.5432982838036701E-2</c:v>
                  </c:pt>
                  <c:pt idx="1">
                    <c:v>4.4641476077664075</c:v>
                  </c:pt>
                  <c:pt idx="2">
                    <c:v>17.596138275000001</c:v>
                  </c:pt>
                  <c:pt idx="3">
                    <c:v>5.9302832430477093</c:v>
                  </c:pt>
                  <c:pt idx="4">
                    <c:v>0.3568998357835782</c:v>
                  </c:pt>
                  <c:pt idx="5">
                    <c:v>8.6583738899999982</c:v>
                  </c:pt>
                </c:numCache>
              </c:numRef>
            </c:plus>
            <c:minus>
              <c:numRef>
                <c:f>'[grafica%20185 (Recuperado).xlsx]185'!$C$14:$H$14</c:f>
                <c:numCache>
                  <c:formatCode>General</c:formatCode>
                  <c:ptCount val="6"/>
                  <c:pt idx="0">
                    <c:v>5.5432982838036701E-2</c:v>
                  </c:pt>
                  <c:pt idx="1">
                    <c:v>4.4641476077664075</c:v>
                  </c:pt>
                  <c:pt idx="2">
                    <c:v>17.596138275000001</c:v>
                  </c:pt>
                  <c:pt idx="3">
                    <c:v>5.9302832430477093</c:v>
                  </c:pt>
                  <c:pt idx="4">
                    <c:v>0.3568998357835782</c:v>
                  </c:pt>
                  <c:pt idx="5">
                    <c:v>8.65837388999999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grafica%20185 (Recuperado).xlsx]185'!$A$9:$A$14</c:f>
              <c:numCache>
                <c:formatCode>General</c:formatCode>
                <c:ptCount val="6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5</c:v>
                </c:pt>
                <c:pt idx="4">
                  <c:v>21</c:v>
                </c:pt>
                <c:pt idx="5">
                  <c:v>30</c:v>
                </c:pt>
              </c:numCache>
            </c:numRef>
          </c:cat>
          <c:val>
            <c:numRef>
              <c:f>'[grafica%20185 (Recuperado).xlsx]185'!$B$7,'[grafica%20185 (Recuperado).xlsx]185'!$F$7,'[grafica%20185 (Recuperado).xlsx]185'!$J$7,'[grafica%20185 (Recuperado).xlsx]185'!$N$7,'[grafica%20185 (Recuperado).xlsx]185'!$R$7,'[grafica%20185 (Recuperado).xlsx]185'!$V$7</c:f>
              <c:numCache>
                <c:formatCode>General</c:formatCode>
                <c:ptCount val="6"/>
                <c:pt idx="0">
                  <c:v>0.72496562766666672</c:v>
                </c:pt>
                <c:pt idx="1">
                  <c:v>9.3000546130000004</c:v>
                </c:pt>
                <c:pt idx="2">
                  <c:v>36.638543495</c:v>
                </c:pt>
                <c:pt idx="3">
                  <c:v>15.168372389333333</c:v>
                </c:pt>
                <c:pt idx="4">
                  <c:v>2.3004908203333332</c:v>
                </c:pt>
                <c:pt idx="5">
                  <c:v>10.784152750000001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grafica%20185 (Recuperado).xlsx]185'!$C$17:$H$17</c15:f>
                <c15:dlblRangeCache>
                  <c:ptCount val="6"/>
                  <c:pt idx="0">
                    <c:v>a</c:v>
                  </c:pt>
                  <c:pt idx="1">
                    <c:v>a</c:v>
                  </c:pt>
                  <c:pt idx="2">
                    <c:v>a</c:v>
                  </c:pt>
                  <c:pt idx="3">
                    <c:v>a</c:v>
                  </c:pt>
                  <c:pt idx="4">
                    <c:v>a</c:v>
                  </c:pt>
                  <c:pt idx="5">
                    <c:v>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D-9EE1-48B3-BDD1-FA2DEE634066}"/>
            </c:ext>
          </c:extLst>
        </c:ser>
        <c:ser>
          <c:idx val="2"/>
          <c:order val="2"/>
          <c:tx>
            <c:strRef>
              <c:f>'[grafica%20185 (Recuperado).xlsx]185'!$G$1</c:f>
              <c:strCache>
                <c:ptCount val="1"/>
                <c:pt idx="0">
                  <c:v>PI414723m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fld id="{1E054F84-1722-41C8-B359-F6B371304022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E-9EE1-48B3-BDD1-FA2DEE634066}"/>
                </c:ext>
              </c:extLst>
            </c:dLbl>
            <c:dLbl>
              <c:idx val="1"/>
              <c:layout>
                <c:manualLayout>
                  <c:x val="0"/>
                  <c:y val="-0.12962962962962971"/>
                </c:manualLayout>
              </c:layout>
              <c:tx>
                <c:rich>
                  <a:bodyPr/>
                  <a:lstStyle/>
                  <a:p>
                    <a:fld id="{AEB2A911-DD05-4D05-A6D4-A238BD31D4F6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F-9EE1-48B3-BDD1-FA2DEE634066}"/>
                </c:ext>
              </c:extLst>
            </c:dLbl>
            <c:dLbl>
              <c:idx val="2"/>
              <c:layout>
                <c:manualLayout>
                  <c:x val="2.7777777777777267E-3"/>
                  <c:y val="-0.18981481481481483"/>
                </c:manualLayout>
              </c:layout>
              <c:tx>
                <c:rich>
                  <a:bodyPr/>
                  <a:lstStyle/>
                  <a:p>
                    <a:fld id="{0086C0F7-6CAF-4540-AB0D-33CA548F2D8B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0-9EE1-48B3-BDD1-FA2DEE634066}"/>
                </c:ext>
              </c:extLst>
            </c:dLbl>
            <c:dLbl>
              <c:idx val="3"/>
              <c:layout>
                <c:manualLayout>
                  <c:x val="0"/>
                  <c:y val="-5.5555555555555511E-2"/>
                </c:manualLayout>
              </c:layout>
              <c:tx>
                <c:rich>
                  <a:bodyPr/>
                  <a:lstStyle/>
                  <a:p>
                    <a:fld id="{7860C916-7E7C-4622-90B0-DDF6C7F20F1A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1-9EE1-48B3-BDD1-FA2DEE634066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C63450B6-B2AB-4AE7-B5A9-1680683ECFA6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2-9EE1-48B3-BDD1-FA2DEE634066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6F2D49E4-0864-42B3-81F6-C758D0422E34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3-9EE1-48B3-BDD1-FA2DEE63406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en-US"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grafica%20185 (Recuperado).xlsx]185'!$C$15:$H$15</c:f>
                <c:numCache>
                  <c:formatCode>General</c:formatCode>
                  <c:ptCount val="6"/>
                  <c:pt idx="0">
                    <c:v>1.2264208914844215</c:v>
                  </c:pt>
                  <c:pt idx="1">
                    <c:v>11.309125827994194</c:v>
                  </c:pt>
                  <c:pt idx="2">
                    <c:v>19.974927318500001</c:v>
                  </c:pt>
                  <c:pt idx="3">
                    <c:v>6.2664377798211097</c:v>
                  </c:pt>
                  <c:pt idx="4">
                    <c:v>0.69467062826123727</c:v>
                  </c:pt>
                  <c:pt idx="5">
                    <c:v>0.49075014425405838</c:v>
                  </c:pt>
                </c:numCache>
              </c:numRef>
            </c:plus>
            <c:minus>
              <c:numRef>
                <c:f>'[grafica%20185 (Recuperado).xlsx]185'!$C$15:$H$15</c:f>
                <c:numCache>
                  <c:formatCode>General</c:formatCode>
                  <c:ptCount val="6"/>
                  <c:pt idx="0">
                    <c:v>1.2264208914844215</c:v>
                  </c:pt>
                  <c:pt idx="1">
                    <c:v>11.309125827994194</c:v>
                  </c:pt>
                  <c:pt idx="2">
                    <c:v>19.974927318500001</c:v>
                  </c:pt>
                  <c:pt idx="3">
                    <c:v>6.2664377798211097</c:v>
                  </c:pt>
                  <c:pt idx="4">
                    <c:v>0.69467062826123727</c:v>
                  </c:pt>
                  <c:pt idx="5">
                    <c:v>0.490750144254058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grafica%20185 (Recuperado).xlsx]185'!$A$9:$A$14</c:f>
              <c:numCache>
                <c:formatCode>General</c:formatCode>
                <c:ptCount val="6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5</c:v>
                </c:pt>
                <c:pt idx="4">
                  <c:v>21</c:v>
                </c:pt>
                <c:pt idx="5">
                  <c:v>30</c:v>
                </c:pt>
              </c:numCache>
            </c:numRef>
          </c:cat>
          <c:val>
            <c:numRef>
              <c:f>'[grafica%20185 (Recuperado).xlsx]185'!$C$7,'[grafica%20185 (Recuperado).xlsx]185'!$G$7,'[grafica%20185 (Recuperado).xlsx]185'!$K$7,'[grafica%20185 (Recuperado).xlsx]185'!$O$7,'[grafica%20185 (Recuperado).xlsx]185'!$S$7,'[grafica%20185 (Recuperado).xlsx]185'!$W$7</c:f>
              <c:numCache>
                <c:formatCode>General</c:formatCode>
                <c:ptCount val="6"/>
                <c:pt idx="0">
                  <c:v>4.6388151086666669</c:v>
                </c:pt>
                <c:pt idx="1">
                  <c:v>16.347551580666664</c:v>
                </c:pt>
                <c:pt idx="2">
                  <c:v>31.860535398499998</c:v>
                </c:pt>
                <c:pt idx="3">
                  <c:v>29.272484600000002</c:v>
                </c:pt>
                <c:pt idx="4">
                  <c:v>3.9630612496666662</c:v>
                </c:pt>
                <c:pt idx="5">
                  <c:v>11.395848976666665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grafica%20185 (Recuperado).xlsx]185'!$C$17:$H$17</c15:f>
                <c15:dlblRangeCache>
                  <c:ptCount val="6"/>
                  <c:pt idx="0">
                    <c:v>a</c:v>
                  </c:pt>
                  <c:pt idx="1">
                    <c:v>a</c:v>
                  </c:pt>
                  <c:pt idx="2">
                    <c:v>a</c:v>
                  </c:pt>
                  <c:pt idx="3">
                    <c:v>a</c:v>
                  </c:pt>
                  <c:pt idx="4">
                    <c:v>a</c:v>
                  </c:pt>
                  <c:pt idx="5">
                    <c:v>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14-9EE1-48B3-BDD1-FA2DEE634066}"/>
            </c:ext>
          </c:extLst>
        </c:ser>
        <c:ser>
          <c:idx val="3"/>
          <c:order val="3"/>
          <c:tx>
            <c:strRef>
              <c:f>'[grafica%20185 (Recuperado).xlsx]185'!$D$1</c:f>
              <c:strCache>
                <c:ptCount val="1"/>
                <c:pt idx="0">
                  <c:v>PI 414723i</c:v>
                </c:pt>
              </c:strCache>
            </c:strRef>
          </c:tx>
          <c:spPr>
            <a:solidFill>
              <a:srgbClr val="EB7525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4.1666666666666664E-2"/>
                </c:manualLayout>
              </c:layout>
              <c:tx>
                <c:rich>
                  <a:bodyPr/>
                  <a:lstStyle/>
                  <a:p>
                    <a:fld id="{278C41FF-F1A3-44C9-AA0F-7EA23A67565A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5-9EE1-48B3-BDD1-FA2DEE634066}"/>
                </c:ext>
              </c:extLst>
            </c:dLbl>
            <c:dLbl>
              <c:idx val="1"/>
              <c:layout>
                <c:manualLayout>
                  <c:x val="0"/>
                  <c:y val="-0.12037037037037036"/>
                </c:manualLayout>
              </c:layout>
              <c:tx>
                <c:rich>
                  <a:bodyPr/>
                  <a:lstStyle/>
                  <a:p>
                    <a:fld id="{926D1B2E-3EF1-4FDB-A410-B050A323DC88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6-9EE1-48B3-BDD1-FA2DEE634066}"/>
                </c:ext>
              </c:extLst>
            </c:dLbl>
            <c:dLbl>
              <c:idx val="2"/>
              <c:layout>
                <c:manualLayout>
                  <c:x val="0"/>
                  <c:y val="-8.3333333333333329E-2"/>
                </c:manualLayout>
              </c:layout>
              <c:tx>
                <c:rich>
                  <a:bodyPr/>
                  <a:lstStyle/>
                  <a:p>
                    <a:fld id="{6CDDDFA4-736C-45D6-991B-00FF24A381A3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7-9EE1-48B3-BDD1-FA2DEE634066}"/>
                </c:ext>
              </c:extLst>
            </c:dLbl>
            <c:dLbl>
              <c:idx val="3"/>
              <c:layout>
                <c:manualLayout>
                  <c:x val="0"/>
                  <c:y val="-0.10648148148148157"/>
                </c:manualLayout>
              </c:layout>
              <c:tx>
                <c:rich>
                  <a:bodyPr/>
                  <a:lstStyle/>
                  <a:p>
                    <a:fld id="{482A2B99-AF2F-4AA5-852B-5519F4AF7B9B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8-9EE1-48B3-BDD1-FA2DEE634066}"/>
                </c:ext>
              </c:extLst>
            </c:dLbl>
            <c:dLbl>
              <c:idx val="4"/>
              <c:layout>
                <c:manualLayout>
                  <c:x val="-1.0185067526415994E-16"/>
                  <c:y val="-4.6296296296296384E-2"/>
                </c:manualLayout>
              </c:layout>
              <c:tx>
                <c:rich>
                  <a:bodyPr/>
                  <a:lstStyle/>
                  <a:p>
                    <a:fld id="{533D8180-C581-416E-8952-A37B6E8DFF65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9-9EE1-48B3-BDD1-FA2DEE634066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0E65689B-AD54-4772-982E-6F499B3B8C5C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A-9EE1-48B3-BDD1-FA2DEE63406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en-US"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grafica%20185 (Recuperado).xlsx]185'!$C$16:$H$16</c:f>
                <c:numCache>
                  <c:formatCode>General</c:formatCode>
                  <c:ptCount val="6"/>
                  <c:pt idx="0">
                    <c:v>3.3434649933339542</c:v>
                  </c:pt>
                  <c:pt idx="1">
                    <c:v>10.081430550598947</c:v>
                  </c:pt>
                  <c:pt idx="2">
                    <c:v>9.0150956399999949</c:v>
                  </c:pt>
                  <c:pt idx="3">
                    <c:v>10.724966340932212</c:v>
                  </c:pt>
                  <c:pt idx="4">
                    <c:v>5.447190410500002</c:v>
                  </c:pt>
                  <c:pt idx="5">
                    <c:v>0</c:v>
                  </c:pt>
                </c:numCache>
              </c:numRef>
            </c:plus>
            <c:minus>
              <c:numRef>
                <c:f>'[grafica%20185 (Recuperado).xlsx]185'!$C$16:$H$16</c:f>
                <c:numCache>
                  <c:formatCode>General</c:formatCode>
                  <c:ptCount val="6"/>
                  <c:pt idx="0">
                    <c:v>3.3434649933339542</c:v>
                  </c:pt>
                  <c:pt idx="1">
                    <c:v>10.081430550598947</c:v>
                  </c:pt>
                  <c:pt idx="2">
                    <c:v>9.0150956399999949</c:v>
                  </c:pt>
                  <c:pt idx="3">
                    <c:v>10.724966340932212</c:v>
                  </c:pt>
                  <c:pt idx="4">
                    <c:v>5.447190410500002</c:v>
                  </c:pt>
                  <c:pt idx="5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grafica%20185 (Recuperado).xlsx]185'!$A$9:$A$14</c:f>
              <c:numCache>
                <c:formatCode>General</c:formatCode>
                <c:ptCount val="6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5</c:v>
                </c:pt>
                <c:pt idx="4">
                  <c:v>21</c:v>
                </c:pt>
                <c:pt idx="5">
                  <c:v>30</c:v>
                </c:pt>
              </c:numCache>
            </c:numRef>
          </c:cat>
          <c:val>
            <c:numRef>
              <c:f>'[grafica%20185 (Recuperado).xlsx]185'!$D$7,'[grafica%20185 (Recuperado).xlsx]185'!$H$7,'[grafica%20185 (Recuperado).xlsx]185'!$L$7,'[grafica%20185 (Recuperado).xlsx]185'!$P$7,'[grafica%20185 (Recuperado).xlsx]185'!$T$7,'[grafica%20185 (Recuperado).xlsx]185'!$X$7</c:f>
              <c:numCache>
                <c:formatCode>General</c:formatCode>
                <c:ptCount val="6"/>
                <c:pt idx="0">
                  <c:v>6.6167652889999999</c:v>
                </c:pt>
                <c:pt idx="1">
                  <c:v>20.645012464000001</c:v>
                </c:pt>
                <c:pt idx="2">
                  <c:v>30.58792966</c:v>
                </c:pt>
                <c:pt idx="3">
                  <c:v>17.917682127666666</c:v>
                </c:pt>
                <c:pt idx="4">
                  <c:v>9.3899772494999993</c:v>
                </c:pt>
                <c:pt idx="5">
                  <c:v>12.45985795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grafica%20185 (Recuperado).xlsx]185'!$C$17:$H$17</c15:f>
                <c15:dlblRangeCache>
                  <c:ptCount val="6"/>
                  <c:pt idx="0">
                    <c:v>a</c:v>
                  </c:pt>
                  <c:pt idx="1">
                    <c:v>a</c:v>
                  </c:pt>
                  <c:pt idx="2">
                    <c:v>a</c:v>
                  </c:pt>
                  <c:pt idx="3">
                    <c:v>a</c:v>
                  </c:pt>
                  <c:pt idx="4">
                    <c:v>a</c:v>
                  </c:pt>
                  <c:pt idx="5">
                    <c:v>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1B-9EE1-48B3-BDD1-FA2DEE6340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327016527"/>
        <c:axId val="1641995503"/>
      </c:barChart>
      <c:catAx>
        <c:axId val="132701652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641995503"/>
        <c:crosses val="autoZero"/>
        <c:auto val="1"/>
        <c:lblAlgn val="ctr"/>
        <c:lblOffset val="100"/>
        <c:noMultiLvlLbl val="0"/>
      </c:catAx>
      <c:valAx>
        <c:axId val="1641995503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32701652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en-US" sz="900" b="0" i="0" u="none" strike="noStrike" kern="1200" baseline="0">
          <a:solidFill>
            <a:schemeClr val="tx1"/>
          </a:solidFill>
          <a:latin typeface="+mn-lt"/>
          <a:ea typeface="+mn-ea"/>
          <a:cs typeface="+mn-cs"/>
        </a:defRPr>
      </a:pPr>
      <a:endParaRPr lang="es-E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vert="horz"/>
          <a:lstStyle/>
          <a:p>
            <a:pPr>
              <a:defRPr/>
            </a:pPr>
            <a:r>
              <a:rPr lang="en-US" sz="1080" b="0" i="0" u="none" strike="noStrike" baseline="0">
                <a:effectLst/>
              </a:rPr>
              <a:t>MELO3C017424.2</a:t>
            </a:r>
            <a:endParaRPr lang="en-GB"/>
          </a:p>
          <a:p>
            <a:pPr>
              <a:defRPr/>
            </a:pPr>
            <a:r>
              <a:rPr lang="en-US" sz="1080" b="0" i="0" u="none" strike="noStrike" baseline="0">
                <a:effectLst/>
              </a:rPr>
              <a:t>Transcription factor bHLH35</a:t>
            </a:r>
            <a:endParaRPr lang="en-GB"/>
          </a:p>
        </c:rich>
      </c:tx>
      <c:layout>
        <c:manualLayout>
          <c:xMode val="edge"/>
          <c:yMode val="edge"/>
          <c:x val="0.33438298337707789"/>
          <c:y val="2.9398148148148142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grafica%20185 (Recuperado).xlsx]424'!$K$8</c:f>
              <c:strCache>
                <c:ptCount val="1"/>
                <c:pt idx="0">
                  <c:v>PSm</c:v>
                </c:pt>
              </c:strCache>
            </c:strRef>
          </c:tx>
          <c:spPr>
            <a:solidFill>
              <a:srgbClr val="9DC3E6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0.22222222222222227"/>
                </c:manualLayout>
              </c:layout>
              <c:tx>
                <c:rich>
                  <a:bodyPr/>
                  <a:lstStyle/>
                  <a:p>
                    <a:fld id="{BF35D9FA-26B1-461F-8B00-0610548D1F5C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0-FBBA-4EE9-B22D-26A80954173E}"/>
                </c:ext>
              </c:extLst>
            </c:dLbl>
            <c:dLbl>
              <c:idx val="1"/>
              <c:layout>
                <c:manualLayout>
                  <c:x val="0"/>
                  <c:y val="-2.2607903178769321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b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FBBA-4EE9-B22D-26A80954173E}"/>
                </c:ext>
              </c:extLst>
            </c:dLbl>
            <c:dLbl>
              <c:idx val="2"/>
              <c:layout>
                <c:manualLayout>
                  <c:x val="0"/>
                  <c:y val="-2.3148148148148234E-2"/>
                </c:manualLayout>
              </c:layout>
              <c:tx>
                <c:rich>
                  <a:bodyPr/>
                  <a:lstStyle/>
                  <a:p>
                    <a:fld id="{EB06D6A6-DFD5-429D-8D00-B9450AAC10A0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2-FBBA-4EE9-B22D-26A80954173E}"/>
                </c:ext>
              </c:extLst>
            </c:dLbl>
            <c:dLbl>
              <c:idx val="3"/>
              <c:layout>
                <c:manualLayout>
                  <c:x val="5.5555555555554534E-3"/>
                  <c:y val="-3.1266404199475064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FBBA-4EE9-B22D-26A80954173E}"/>
                </c:ext>
              </c:extLst>
            </c:dLbl>
            <c:dLbl>
              <c:idx val="4"/>
              <c:layout>
                <c:manualLayout>
                  <c:x val="0"/>
                  <c:y val="8.6580086580085782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b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FBBA-4EE9-B22D-26A80954173E}"/>
                </c:ext>
              </c:extLst>
            </c:dLbl>
            <c:dLbl>
              <c:idx val="5"/>
              <c:layout>
                <c:manualLayout>
                  <c:x val="0"/>
                  <c:y val="4.5687518226887455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FBBA-4EE9-B22D-26A80954173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vert="horz"/>
              <a:lstStyle/>
              <a:p>
                <a:pPr>
                  <a:defRPr/>
                </a:pPr>
                <a:endParaRPr lang="es-ES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grafica%20185 (Recuperado).xlsx]424'!$K$10,'[grafica%20185 (Recuperado).xlsx]424'!$O$10,'[grafica%20185 (Recuperado).xlsx]424'!$S$10,'[grafica%20185 (Recuperado).xlsx]424'!$W$10,'[grafica%20185 (Recuperado).xlsx]424'!$AA$10,'[grafica%20185 (Recuperado).xlsx]424'!$AE$10</c:f>
                <c:numCache>
                  <c:formatCode>General</c:formatCode>
                  <c:ptCount val="6"/>
                  <c:pt idx="0">
                    <c:v>33.603398769537208</c:v>
                  </c:pt>
                  <c:pt idx="1">
                    <c:v>6.0070046003688784</c:v>
                  </c:pt>
                  <c:pt idx="2">
                    <c:v>5.2003163217880202</c:v>
                  </c:pt>
                  <c:pt idx="3">
                    <c:v>1.4671698895590224</c:v>
                  </c:pt>
                  <c:pt idx="4">
                    <c:v>0.27246324846424191</c:v>
                  </c:pt>
                  <c:pt idx="5">
                    <c:v>2.8821801909163329</c:v>
                  </c:pt>
                </c:numCache>
              </c:numRef>
            </c:plus>
            <c:minus>
              <c:numRef>
                <c:f>'[grafica%20185 (Recuperado).xlsx]424'!$K$10,'[grafica%20185 (Recuperado).xlsx]424'!$O$10,'[grafica%20185 (Recuperado).xlsx]424'!$S$10,'[grafica%20185 (Recuperado).xlsx]424'!$W$10,'[grafica%20185 (Recuperado).xlsx]424'!$AA$10,'[grafica%20185 (Recuperado).xlsx]424'!$AE$10</c:f>
                <c:numCache>
                  <c:formatCode>General</c:formatCode>
                  <c:ptCount val="6"/>
                  <c:pt idx="0">
                    <c:v>33.603398769537208</c:v>
                  </c:pt>
                  <c:pt idx="1">
                    <c:v>6.0070046003688784</c:v>
                  </c:pt>
                  <c:pt idx="2">
                    <c:v>5.2003163217880202</c:v>
                  </c:pt>
                  <c:pt idx="3">
                    <c:v>1.4671698895590224</c:v>
                  </c:pt>
                  <c:pt idx="4">
                    <c:v>0.27246324846424191</c:v>
                  </c:pt>
                  <c:pt idx="5">
                    <c:v>2.8821801909163329</c:v>
                  </c:pt>
                </c:numCache>
              </c:numRef>
            </c:minus>
          </c:errBars>
          <c:cat>
            <c:numRef>
              <c:f>'[grafica%20185 (Recuperado).xlsx]424'!$K$12:$K$17</c:f>
              <c:numCache>
                <c:formatCode>General</c:formatCode>
                <c:ptCount val="6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5</c:v>
                </c:pt>
                <c:pt idx="4">
                  <c:v>21</c:v>
                </c:pt>
                <c:pt idx="5">
                  <c:v>30</c:v>
                </c:pt>
              </c:numCache>
            </c:numRef>
          </c:cat>
          <c:val>
            <c:numRef>
              <c:f>'[grafica%20185 (Recuperado).xlsx]424'!$K$9,'[grafica%20185 (Recuperado).xlsx]424'!$O$9,'[grafica%20185 (Recuperado).xlsx]424'!$S$9,'[grafica%20185 (Recuperado).xlsx]424'!$W$9,'[grafica%20185 (Recuperado).xlsx]424'!$AA$9,'[grafica%20185 (Recuperado).xlsx]424'!$AE$9</c:f>
              <c:numCache>
                <c:formatCode>General</c:formatCode>
                <c:ptCount val="6"/>
                <c:pt idx="0">
                  <c:v>37.985633207200763</c:v>
                </c:pt>
                <c:pt idx="1">
                  <c:v>19.716193318171161</c:v>
                </c:pt>
                <c:pt idx="2">
                  <c:v>16.605886509969238</c:v>
                </c:pt>
                <c:pt idx="3">
                  <c:v>12.934443935883905</c:v>
                </c:pt>
                <c:pt idx="4">
                  <c:v>3.4253353923811991</c:v>
                </c:pt>
                <c:pt idx="5">
                  <c:v>9.4273243936194042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grafica%20185 (Recuperado).xlsx]424'!$S$12:$X$12</c15:f>
                <c15:dlblRangeCache>
                  <c:ptCount val="6"/>
                  <c:pt idx="0">
                    <c:v>a</c:v>
                  </c:pt>
                  <c:pt idx="1">
                    <c:v>ab</c:v>
                  </c:pt>
                  <c:pt idx="2">
                    <c:v>a</c:v>
                  </c:pt>
                  <c:pt idx="3">
                    <c:v>a</c:v>
                  </c:pt>
                  <c:pt idx="4">
                    <c:v>ab</c:v>
                  </c:pt>
                  <c:pt idx="5">
                    <c:v>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6-FBBA-4EE9-B22D-26A80954173E}"/>
            </c:ext>
          </c:extLst>
        </c:ser>
        <c:ser>
          <c:idx val="1"/>
          <c:order val="1"/>
          <c:tx>
            <c:strRef>
              <c:f>'[grafica%20185 (Recuperado).xlsx]424'!$L$8</c:f>
              <c:strCache>
                <c:ptCount val="1"/>
                <c:pt idx="0">
                  <c:v>PSi</c:v>
                </c:pt>
              </c:strCache>
            </c:strRef>
          </c:tx>
          <c:spPr>
            <a:solidFill>
              <a:srgbClr val="4472C4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-2.5462668816039986E-17"/>
                  <c:y val="-6.4814814814814811E-2"/>
                </c:manualLayout>
              </c:layout>
              <c:tx>
                <c:rich>
                  <a:bodyPr/>
                  <a:lstStyle/>
                  <a:p>
                    <a:fld id="{2D6BB944-8A92-4B71-BB38-B37D7134019D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7-FBBA-4EE9-B22D-26A80954173E}"/>
                </c:ext>
              </c:extLst>
            </c:dLbl>
            <c:dLbl>
              <c:idx val="1"/>
              <c:layout>
                <c:manualLayout>
                  <c:x val="0"/>
                  <c:y val="-6.9714566929133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FBBA-4EE9-B22D-26A80954173E}"/>
                </c:ext>
              </c:extLst>
            </c:dLbl>
            <c:dLbl>
              <c:idx val="2"/>
              <c:layout>
                <c:manualLayout>
                  <c:x val="0"/>
                  <c:y val="-1.7316017316017316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FBBA-4EE9-B22D-26A80954173E}"/>
                </c:ext>
              </c:extLst>
            </c:dLbl>
            <c:dLbl>
              <c:idx val="3"/>
              <c:layout>
                <c:manualLayout>
                  <c:x val="-2.7777777777777779E-3"/>
                  <c:y val="-4.3290043290044088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b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FBBA-4EE9-B22D-26A80954173E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AC665006-7924-4B36-A3C0-19CC952E110E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B-FBBA-4EE9-B22D-26A80954173E}"/>
                </c:ext>
              </c:extLst>
            </c:dLbl>
            <c:dLbl>
              <c:idx val="5"/>
              <c:layout>
                <c:manualLayout>
                  <c:x val="1.0185067526415994E-16"/>
                  <c:y val="1.298701298701298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FBBA-4EE9-B22D-26A80954173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vert="horz"/>
              <a:lstStyle/>
              <a:p>
                <a:pPr>
                  <a:defRPr/>
                </a:pPr>
                <a:endParaRPr lang="es-ES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grafica%20185 (Recuperado).xlsx]424'!$L$10,'[grafica%20185 (Recuperado).xlsx]424'!$P$10,'[grafica%20185 (Recuperado).xlsx]424'!$T$10,'[grafica%20185 (Recuperado).xlsx]424'!$X$10,'[grafica%20185 (Recuperado).xlsx]424'!$AB$10,'[grafica%20185 (Recuperado).xlsx]424'!$AF$10</c:f>
                <c:numCache>
                  <c:formatCode>General</c:formatCode>
                  <c:ptCount val="6"/>
                  <c:pt idx="0">
                    <c:v>7.7255366847084144</c:v>
                  </c:pt>
                  <c:pt idx="1">
                    <c:v>14.858048150115323</c:v>
                  </c:pt>
                  <c:pt idx="2">
                    <c:v>1.1947629677645375</c:v>
                  </c:pt>
                  <c:pt idx="3">
                    <c:v>2.3720522587672854</c:v>
                  </c:pt>
                  <c:pt idx="4">
                    <c:v>0.77454039943271946</c:v>
                  </c:pt>
                  <c:pt idx="5">
                    <c:v>2.1633478697201163</c:v>
                  </c:pt>
                </c:numCache>
              </c:numRef>
            </c:plus>
            <c:minus>
              <c:numRef>
                <c:f>'[grafica%20185 (Recuperado).xlsx]424'!$L$10,'[grafica%20185 (Recuperado).xlsx]424'!$P$10,'[grafica%20185 (Recuperado).xlsx]424'!$T$10,'[grafica%20185 (Recuperado).xlsx]424'!$X$10,'[grafica%20185 (Recuperado).xlsx]424'!$AB$10,'[grafica%20185 (Recuperado).xlsx]424'!$AF$10</c:f>
                <c:numCache>
                  <c:formatCode>General</c:formatCode>
                  <c:ptCount val="6"/>
                  <c:pt idx="0">
                    <c:v>7.7255366847084144</c:v>
                  </c:pt>
                  <c:pt idx="1">
                    <c:v>14.858048150115323</c:v>
                  </c:pt>
                  <c:pt idx="2">
                    <c:v>1.1947629677645375</c:v>
                  </c:pt>
                  <c:pt idx="3">
                    <c:v>2.3720522587672854</c:v>
                  </c:pt>
                  <c:pt idx="4">
                    <c:v>0.77454039943271946</c:v>
                  </c:pt>
                  <c:pt idx="5">
                    <c:v>2.1633478697201163</c:v>
                  </c:pt>
                </c:numCache>
              </c:numRef>
            </c:minus>
          </c:errBars>
          <c:val>
            <c:numRef>
              <c:f>'[grafica%20185 (Recuperado).xlsx]424'!$L$9,'[grafica%20185 (Recuperado).xlsx]424'!$P$9,'[grafica%20185 (Recuperado).xlsx]424'!$T$9,'[grafica%20185 (Recuperado).xlsx]424'!$X$9,'[grafica%20185 (Recuperado).xlsx]424'!$AB$9,'[grafica%20185 (Recuperado).xlsx]424'!$AF$9</c:f>
              <c:numCache>
                <c:formatCode>General</c:formatCode>
                <c:ptCount val="6"/>
                <c:pt idx="0">
                  <c:v>26.708394886580226</c:v>
                </c:pt>
                <c:pt idx="1">
                  <c:v>40.34464189738496</c:v>
                </c:pt>
                <c:pt idx="2">
                  <c:v>20.915843111719965</c:v>
                </c:pt>
                <c:pt idx="3">
                  <c:v>8.5748735218073513</c:v>
                </c:pt>
                <c:pt idx="4">
                  <c:v>4.7584085118738555</c:v>
                </c:pt>
                <c:pt idx="5">
                  <c:v>9.1821510707914484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grafica%20185 (Recuperado).xlsx]424'!$S$13:$X$13</c15:f>
                <c15:dlblRangeCache>
                  <c:ptCount val="6"/>
                  <c:pt idx="0">
                    <c:v>a</c:v>
                  </c:pt>
                  <c:pt idx="1">
                    <c:v>a</c:v>
                  </c:pt>
                  <c:pt idx="2">
                    <c:v>a</c:v>
                  </c:pt>
                  <c:pt idx="3">
                    <c:v>ab</c:v>
                  </c:pt>
                  <c:pt idx="4">
                    <c:v>a</c:v>
                  </c:pt>
                  <c:pt idx="5">
                    <c:v>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D-FBBA-4EE9-B22D-26A80954173E}"/>
            </c:ext>
          </c:extLst>
        </c:ser>
        <c:ser>
          <c:idx val="2"/>
          <c:order val="2"/>
          <c:tx>
            <c:strRef>
              <c:f>'[grafica%20185 (Recuperado).xlsx]424'!$N$8</c:f>
              <c:strCache>
                <c:ptCount val="1"/>
                <c:pt idx="0">
                  <c:v>PI 414723i</c:v>
                </c:pt>
              </c:strCache>
            </c:strRef>
          </c:tx>
          <c:spPr>
            <a:solidFill>
              <a:srgbClr val="F4B183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3.359798775153106E-3"/>
                  <c:y val="-6.3210848643927996E-4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E-FBBA-4EE9-B22D-26A80954173E}"/>
                </c:ext>
              </c:extLst>
            </c:dLbl>
            <c:dLbl>
              <c:idx val="1"/>
              <c:layout>
                <c:manualLayout>
                  <c:x val="0"/>
                  <c:y val="1.298701298701298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FBBA-4EE9-B22D-26A80954173E}"/>
                </c:ext>
              </c:extLst>
            </c:dLbl>
            <c:dLbl>
              <c:idx val="2"/>
              <c:layout>
                <c:manualLayout>
                  <c:x val="0"/>
                  <c:y val="-1.479075532225138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0-FBBA-4EE9-B22D-26A80954173E}"/>
                </c:ext>
              </c:extLst>
            </c:dLbl>
            <c:dLbl>
              <c:idx val="3"/>
              <c:layout>
                <c:manualLayout>
                  <c:x val="0"/>
                  <c:y val="-2.5974025974026052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FBBA-4EE9-B22D-26A80954173E}"/>
                </c:ext>
              </c:extLst>
            </c:dLbl>
            <c:dLbl>
              <c:idx val="4"/>
              <c:layout>
                <c:manualLayout>
                  <c:x val="0"/>
                  <c:y val="1.136373578302703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2-FBBA-4EE9-B22D-26A80954173E}"/>
                </c:ext>
              </c:extLst>
            </c:dLbl>
            <c:dLbl>
              <c:idx val="5"/>
              <c:layout>
                <c:manualLayout>
                  <c:x val="0"/>
                  <c:y val="1.2987012987013066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3-FBBA-4EE9-B22D-26A80954173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vert="horz"/>
              <a:lstStyle/>
              <a:p>
                <a:pPr>
                  <a:defRPr/>
                </a:pPr>
                <a:endParaRPr lang="es-ES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grafica%20185 (Recuperado).xlsx]424'!$M$10,'[grafica%20185 (Recuperado).xlsx]424'!$Q$10,'[grafica%20185 (Recuperado).xlsx]424'!$U$10,'[grafica%20185 (Recuperado).xlsx]424'!$Y$10,'[grafica%20185 (Recuperado).xlsx]424'!$AC$10,'[grafica%20185 (Recuperado).xlsx]424'!$AG$10</c:f>
                <c:numCache>
                  <c:formatCode>General</c:formatCode>
                  <c:ptCount val="6"/>
                  <c:pt idx="0">
                    <c:v>1.7633863782486776</c:v>
                  </c:pt>
                  <c:pt idx="1">
                    <c:v>1.2352290313959164</c:v>
                  </c:pt>
                  <c:pt idx="2">
                    <c:v>5.8821469788180183</c:v>
                  </c:pt>
                  <c:pt idx="3">
                    <c:v>1.6401347591969222</c:v>
                  </c:pt>
                  <c:pt idx="4">
                    <c:v>0.68390898046884752</c:v>
                  </c:pt>
                  <c:pt idx="5">
                    <c:v>1.0959659538880044</c:v>
                  </c:pt>
                </c:numCache>
              </c:numRef>
            </c:plus>
            <c:minus>
              <c:numRef>
                <c:f>'[grafica%20185 (Recuperado).xlsx]424'!$M$10,'[grafica%20185 (Recuperado).xlsx]424'!$Q$10,'[grafica%20185 (Recuperado).xlsx]424'!$U$10,'[grafica%20185 (Recuperado).xlsx]424'!$Y$10,'[grafica%20185 (Recuperado).xlsx]424'!$AC$10,'[grafica%20185 (Recuperado).xlsx]424'!$AG$10</c:f>
                <c:numCache>
                  <c:formatCode>General</c:formatCode>
                  <c:ptCount val="6"/>
                  <c:pt idx="0">
                    <c:v>1.7633863782486776</c:v>
                  </c:pt>
                  <c:pt idx="1">
                    <c:v>1.2352290313959164</c:v>
                  </c:pt>
                  <c:pt idx="2">
                    <c:v>5.8821469788180183</c:v>
                  </c:pt>
                  <c:pt idx="3">
                    <c:v>1.6401347591969222</c:v>
                  </c:pt>
                  <c:pt idx="4">
                    <c:v>0.68390898046884752</c:v>
                  </c:pt>
                  <c:pt idx="5">
                    <c:v>1.0959659538880044</c:v>
                  </c:pt>
                </c:numCache>
              </c:numRef>
            </c:minus>
          </c:errBars>
          <c:val>
            <c:numRef>
              <c:f>'[grafica%20185 (Recuperado).xlsx]424'!$M$9,'[grafica%20185 (Recuperado).xlsx]424'!$Q$9,'[grafica%20185 (Recuperado).xlsx]424'!$U$9,'[grafica%20185 (Recuperado).xlsx]424'!$Y$9,'[grafica%20185 (Recuperado).xlsx]424'!$AC$9,'[grafica%20185 (Recuperado).xlsx]424'!$AG$9</c:f>
              <c:numCache>
                <c:formatCode>General</c:formatCode>
                <c:ptCount val="6"/>
                <c:pt idx="0">
                  <c:v>5.7624908633568994</c:v>
                </c:pt>
                <c:pt idx="1">
                  <c:v>6.008438092785684</c:v>
                </c:pt>
                <c:pt idx="2">
                  <c:v>14.416804922380859</c:v>
                </c:pt>
                <c:pt idx="3">
                  <c:v>3.1728132088485839</c:v>
                </c:pt>
                <c:pt idx="4">
                  <c:v>2.0780518042706304</c:v>
                </c:pt>
                <c:pt idx="5">
                  <c:v>5.8870525573073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FBBA-4EE9-B22D-26A80954173E}"/>
            </c:ext>
          </c:extLst>
        </c:ser>
        <c:ser>
          <c:idx val="3"/>
          <c:order val="3"/>
          <c:tx>
            <c:strRef>
              <c:f>'[grafica%20185 (Recuperado).xlsx]424'!$M$8</c:f>
              <c:strCache>
                <c:ptCount val="1"/>
                <c:pt idx="0">
                  <c:v>PI414723m</c:v>
                </c:pt>
              </c:strCache>
            </c:strRef>
          </c:tx>
          <c:spPr>
            <a:solidFill>
              <a:srgbClr val="ED7D31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6.7195767195767199E-3"/>
                  <c:y val="8.6581790123456785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FBBA-4EE9-B22D-26A80954173E}"/>
                </c:ext>
              </c:extLst>
            </c:dLbl>
            <c:dLbl>
              <c:idx val="1"/>
              <c:layout>
                <c:manualLayout>
                  <c:x val="0"/>
                  <c:y val="-2.164502164502172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b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6-FBBA-4EE9-B22D-26A80954173E}"/>
                </c:ext>
              </c:extLst>
            </c:dLbl>
            <c:dLbl>
              <c:idx val="2"/>
              <c:layout>
                <c:manualLayout>
                  <c:x val="-2.7777777777777779E-3"/>
                  <c:y val="8.6580086580085782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7-FBBA-4EE9-B22D-26A80954173E}"/>
                </c:ext>
              </c:extLst>
            </c:dLbl>
            <c:dLbl>
              <c:idx val="3"/>
              <c:layout>
                <c:manualLayout>
                  <c:x val="-1.0185067526415994E-16"/>
                  <c:y val="8.658008658008658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8-FBBA-4EE9-B22D-26A80954173E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69E340DF-7FAC-421A-AC3B-33D6871329BE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9-FBBA-4EE9-B22D-26A80954173E}"/>
                </c:ext>
              </c:extLst>
            </c:dLbl>
            <c:dLbl>
              <c:idx val="5"/>
              <c:layout>
                <c:manualLayout>
                  <c:x val="0"/>
                  <c:y val="-1.2385899679206851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A-FBBA-4EE9-B22D-26A80954173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vert="horz"/>
              <a:lstStyle/>
              <a:p>
                <a:pPr>
                  <a:defRPr/>
                </a:pPr>
                <a:endParaRPr lang="es-ES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grafica%20185 (Recuperado).xlsx]424'!$N$10,'[grafica%20185 (Recuperado).xlsx]424'!$R$10,'[grafica%20185 (Recuperado).xlsx]424'!$V$10,'[grafica%20185 (Recuperado).xlsx]424'!$Z$10,'[grafica%20185 (Recuperado).xlsx]424'!$AD$10,'[grafica%20185 (Recuperado).xlsx]424'!$AH$10</c:f>
                <c:numCache>
                  <c:formatCode>General</c:formatCode>
                  <c:ptCount val="6"/>
                  <c:pt idx="0">
                    <c:v>0.52971327862945994</c:v>
                  </c:pt>
                  <c:pt idx="1">
                    <c:v>4.4500962625156824</c:v>
                  </c:pt>
                  <c:pt idx="2">
                    <c:v>2.5191890968330259</c:v>
                  </c:pt>
                  <c:pt idx="3">
                    <c:v>2.9345646441876503</c:v>
                  </c:pt>
                  <c:pt idx="4">
                    <c:v>1.0814443431958309</c:v>
                  </c:pt>
                  <c:pt idx="5">
                    <c:v>4.121150088021392</c:v>
                  </c:pt>
                </c:numCache>
              </c:numRef>
            </c:plus>
            <c:minus>
              <c:numRef>
                <c:f>'[grafica%20185 (Recuperado).xlsx]424'!$N$10,'[grafica%20185 (Recuperado).xlsx]424'!$R$10,'[grafica%20185 (Recuperado).xlsx]424'!$V$10,'[grafica%20185 (Recuperado).xlsx]424'!$Z$10,'[grafica%20185 (Recuperado).xlsx]424'!$AD$10,'[grafica%20185 (Recuperado).xlsx]424'!$AH$10</c:f>
                <c:numCache>
                  <c:formatCode>General</c:formatCode>
                  <c:ptCount val="6"/>
                  <c:pt idx="0">
                    <c:v>0.52971327862945994</c:v>
                  </c:pt>
                  <c:pt idx="1">
                    <c:v>4.4500962625156824</c:v>
                  </c:pt>
                  <c:pt idx="2">
                    <c:v>2.5191890968330259</c:v>
                  </c:pt>
                  <c:pt idx="3">
                    <c:v>2.9345646441876503</c:v>
                  </c:pt>
                  <c:pt idx="4">
                    <c:v>1.0814443431958309</c:v>
                  </c:pt>
                  <c:pt idx="5">
                    <c:v>4.121150088021392</c:v>
                  </c:pt>
                </c:numCache>
              </c:numRef>
            </c:minus>
          </c:errBars>
          <c:val>
            <c:numRef>
              <c:f>'[grafica%20185 (Recuperado).xlsx]424'!$N$9,'[grafica%20185 (Recuperado).xlsx]424'!$R$9,'[grafica%20185 (Recuperado).xlsx]424'!$V$9,'[grafica%20185 (Recuperado).xlsx]424'!$Z$9,'[grafica%20185 (Recuperado).xlsx]424'!$AD$9,'[grafica%20185 (Recuperado).xlsx]424'!$AH$9</c:f>
              <c:numCache>
                <c:formatCode>General</c:formatCode>
                <c:ptCount val="6"/>
                <c:pt idx="0">
                  <c:v>3.7086569419288238</c:v>
                </c:pt>
                <c:pt idx="1">
                  <c:v>17.652095023402278</c:v>
                </c:pt>
                <c:pt idx="2">
                  <c:v>10.734603407080861</c:v>
                </c:pt>
                <c:pt idx="3">
                  <c:v>8.707132766288181</c:v>
                </c:pt>
                <c:pt idx="4">
                  <c:v>4.6081797295932745</c:v>
                </c:pt>
                <c:pt idx="5">
                  <c:v>11.423360970436276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grafica%20185 (Recuperado).xlsx]424'!$S$15:$X$15</c15:f>
                <c15:dlblRangeCache>
                  <c:ptCount val="6"/>
                  <c:pt idx="0">
                    <c:v>a</c:v>
                  </c:pt>
                  <c:pt idx="1">
                    <c:v>ab</c:v>
                  </c:pt>
                  <c:pt idx="2">
                    <c:v>a</c:v>
                  </c:pt>
                  <c:pt idx="3">
                    <c:v>b</c:v>
                  </c:pt>
                  <c:pt idx="4">
                    <c:v>ab</c:v>
                  </c:pt>
                  <c:pt idx="5">
                    <c:v>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1B-FBBA-4EE9-B22D-26A80954173E}"/>
            </c:ext>
          </c:extLst>
        </c:ser>
        <c:dLbls>
          <c:dLblPos val="inBase"/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239456512"/>
        <c:axId val="415757904"/>
      </c:barChart>
      <c:catAx>
        <c:axId val="2394565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s-ES"/>
          </a:p>
        </c:txPr>
        <c:crossAx val="415757904"/>
        <c:crosses val="autoZero"/>
        <c:auto val="1"/>
        <c:lblAlgn val="ctr"/>
        <c:lblOffset val="100"/>
        <c:noMultiLvlLbl val="0"/>
      </c:catAx>
      <c:valAx>
        <c:axId val="4157579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s-ES"/>
          </a:p>
        </c:txPr>
        <c:crossAx val="239456512"/>
        <c:crosses val="autoZero"/>
        <c:crossBetween val="between"/>
      </c:valAx>
    </c:plotArea>
    <c:legend>
      <c:legendPos val="b"/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s-E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en-US" sz="900" b="0" i="0" u="none" strike="noStrike" kern="1200" baseline="0">
          <a:solidFill>
            <a:schemeClr val="tx1"/>
          </a:solidFill>
          <a:latin typeface="+mn-lt"/>
          <a:ea typeface="+mn-ea"/>
          <a:cs typeface="+mn-cs"/>
        </a:defRPr>
      </a:pPr>
      <a:endParaRPr lang="es-E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108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080" b="0" i="0" u="none" strike="noStrike" baseline="0">
                <a:effectLst/>
              </a:rPr>
              <a:t>MELO3C029682.2</a:t>
            </a:r>
            <a:endParaRPr lang="en-US"/>
          </a:p>
          <a:p>
            <a:pPr algn="ctr" rtl="0">
              <a:defRPr lang="en-US" sz="108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080" b="0" i="0" u="none" strike="noStrike" baseline="0">
                <a:effectLst/>
              </a:rPr>
              <a:t>Transcriptional corepressor LEUNIG</a:t>
            </a:r>
            <a:endParaRPr lang="en-US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grafica%20185 (Recuperado).xlsx]682'!$K$8</c:f>
              <c:strCache>
                <c:ptCount val="1"/>
                <c:pt idx="0">
                  <c:v>PSm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40000"/>
                  <a:lumOff val="60000"/>
                </a:schemeClr>
              </a:solidFill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fld id="{402BB725-F16B-4448-9144-AA4EA3D1FE29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0-A908-4791-AE24-BEDADFD2AC1D}"/>
                </c:ext>
              </c:extLst>
            </c:dLbl>
            <c:dLbl>
              <c:idx val="1"/>
              <c:layout>
                <c:manualLayout>
                  <c:x val="-5.0925337632079971E-17"/>
                  <c:y val="-2.7777777777777863E-2"/>
                </c:manualLayout>
              </c:layout>
              <c:tx>
                <c:rich>
                  <a:bodyPr/>
                  <a:lstStyle/>
                  <a:p>
                    <a:fld id="{87A3C37F-4008-4ACC-8D0D-C90C38B6BB18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A908-4791-AE24-BEDADFD2AC1D}"/>
                </c:ext>
              </c:extLst>
            </c:dLbl>
            <c:dLbl>
              <c:idx val="2"/>
              <c:layout>
                <c:manualLayout>
                  <c:x val="-2.7777777777777779E-3"/>
                  <c:y val="-5.5555555555555552E-2"/>
                </c:manualLayout>
              </c:layout>
              <c:tx>
                <c:rich>
                  <a:bodyPr/>
                  <a:lstStyle/>
                  <a:p>
                    <a:fld id="{C9C0BA2B-7911-459D-BB60-7C02AEA214A0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2-A908-4791-AE24-BEDADFD2AC1D}"/>
                </c:ext>
              </c:extLst>
            </c:dLbl>
            <c:dLbl>
              <c:idx val="3"/>
              <c:layout>
                <c:manualLayout>
                  <c:x val="0"/>
                  <c:y val="-5.5555555555555643E-2"/>
                </c:manualLayout>
              </c:layout>
              <c:tx>
                <c:rich>
                  <a:bodyPr/>
                  <a:lstStyle/>
                  <a:p>
                    <a:fld id="{095485BF-DEBC-4A07-A9E3-CCC4DEDDE29A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3-A908-4791-AE24-BEDADFD2AC1D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1ABC84D8-BAF5-4CC7-8F72-FE89248CC4CF}" type="CELLRANGE">
                      <a:rPr lang="es-E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4-A908-4791-AE24-BEDADFD2AC1D}"/>
                </c:ext>
              </c:extLst>
            </c:dLbl>
            <c:dLbl>
              <c:idx val="5"/>
              <c:layout>
                <c:manualLayout>
                  <c:x val="-2.7777777777777779E-3"/>
                  <c:y val="-4.6296296296297144E-3"/>
                </c:manualLayout>
              </c:layout>
              <c:tx>
                <c:rich>
                  <a:bodyPr/>
                  <a:lstStyle/>
                  <a:p>
                    <a:fld id="{9A509DA4-3C73-48C4-BC67-33C350B01BDC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A908-4791-AE24-BEDADFD2AC1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en-US"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grafica%20185 (Recuperado).xlsx]682'!$K$10,'[grafica%20185 (Recuperado).xlsx]682'!$O$10,'[grafica%20185 (Recuperado).xlsx]682'!$S$10,'[grafica%20185 (Recuperado).xlsx]682'!$W$10,'[grafica%20185 (Recuperado).xlsx]682'!$AA$10,'[grafica%20185 (Recuperado).xlsx]682'!$AE$10</c:f>
                <c:numCache>
                  <c:formatCode>General</c:formatCode>
                  <c:ptCount val="6"/>
                  <c:pt idx="0">
                    <c:v>8.2223766144119637E-2</c:v>
                  </c:pt>
                  <c:pt idx="1">
                    <c:v>0.89607846110883038</c:v>
                  </c:pt>
                  <c:pt idx="2">
                    <c:v>2.6627499247125725</c:v>
                  </c:pt>
                  <c:pt idx="3">
                    <c:v>2.9021349901071294</c:v>
                  </c:pt>
                  <c:pt idx="4">
                    <c:v>0.42551724839527816</c:v>
                  </c:pt>
                  <c:pt idx="5">
                    <c:v>0.2976272094765991</c:v>
                  </c:pt>
                </c:numCache>
              </c:numRef>
            </c:plus>
            <c:minus>
              <c:numRef>
                <c:f>'[grafica%20185 (Recuperado).xlsx]682'!$K$10,'[grafica%20185 (Recuperado).xlsx]682'!$O$10,'[grafica%20185 (Recuperado).xlsx]682'!$S$10,'[grafica%20185 (Recuperado).xlsx]682'!$W$10,'[grafica%20185 (Recuperado).xlsx]682'!$AA$10,'[grafica%20185 (Recuperado).xlsx]682'!$AE$10</c:f>
                <c:numCache>
                  <c:formatCode>General</c:formatCode>
                  <c:ptCount val="6"/>
                  <c:pt idx="0">
                    <c:v>8.2223766144119637E-2</c:v>
                  </c:pt>
                  <c:pt idx="1">
                    <c:v>0.89607846110883038</c:v>
                  </c:pt>
                  <c:pt idx="2">
                    <c:v>2.6627499247125725</c:v>
                  </c:pt>
                  <c:pt idx="3">
                    <c:v>2.9021349901071294</c:v>
                  </c:pt>
                  <c:pt idx="4">
                    <c:v>0.42551724839527816</c:v>
                  </c:pt>
                  <c:pt idx="5">
                    <c:v>0.2976272094765991</c:v>
                  </c:pt>
                </c:numCache>
              </c:numRef>
            </c:minus>
          </c:errBars>
          <c:cat>
            <c:numRef>
              <c:f>'[grafica%20185 (Recuperado).xlsx]682'!$K$12:$K$17</c:f>
              <c:numCache>
                <c:formatCode>General</c:formatCode>
                <c:ptCount val="6"/>
                <c:pt idx="0">
                  <c:v>3</c:v>
                </c:pt>
                <c:pt idx="1">
                  <c:v>6</c:v>
                </c:pt>
                <c:pt idx="2">
                  <c:v>9</c:v>
                </c:pt>
                <c:pt idx="3">
                  <c:v>15</c:v>
                </c:pt>
                <c:pt idx="4">
                  <c:v>21</c:v>
                </c:pt>
                <c:pt idx="5">
                  <c:v>30</c:v>
                </c:pt>
              </c:numCache>
            </c:numRef>
          </c:cat>
          <c:val>
            <c:numRef>
              <c:f>'[grafica%20185 (Recuperado).xlsx]682'!$K$9,'[grafica%20185 (Recuperado).xlsx]682'!$O$9,'[grafica%20185 (Recuperado).xlsx]682'!$S$9,'[grafica%20185 (Recuperado).xlsx]682'!$W$9,'[grafica%20185 (Recuperado).xlsx]682'!$AA$9,'[grafica%20185 (Recuperado).xlsx]682'!$AE$9</c:f>
              <c:numCache>
                <c:formatCode>General</c:formatCode>
                <c:ptCount val="6"/>
                <c:pt idx="0">
                  <c:v>7.9085396077601278</c:v>
                </c:pt>
                <c:pt idx="1">
                  <c:v>6.0174541884110191</c:v>
                </c:pt>
                <c:pt idx="2">
                  <c:v>4.9495548986463875</c:v>
                </c:pt>
                <c:pt idx="3">
                  <c:v>2.9474461876025808</c:v>
                </c:pt>
                <c:pt idx="4">
                  <c:v>1.4022244658263168</c:v>
                </c:pt>
                <c:pt idx="5">
                  <c:v>2.2652988346760345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grafica%20185 (Recuperado).xlsx]185'!$C$17:$H$17</c15:f>
                <c15:dlblRangeCache>
                  <c:ptCount val="6"/>
                  <c:pt idx="0">
                    <c:v>a</c:v>
                  </c:pt>
                  <c:pt idx="1">
                    <c:v>a</c:v>
                  </c:pt>
                  <c:pt idx="2">
                    <c:v>a</c:v>
                  </c:pt>
                  <c:pt idx="3">
                    <c:v>a</c:v>
                  </c:pt>
                  <c:pt idx="4">
                    <c:v>a</c:v>
                  </c:pt>
                  <c:pt idx="5">
                    <c:v>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6-A908-4791-AE24-BEDADFD2AC1D}"/>
            </c:ext>
          </c:extLst>
        </c:ser>
        <c:ser>
          <c:idx val="1"/>
          <c:order val="1"/>
          <c:tx>
            <c:strRef>
              <c:f>'[grafica%20185 (Recuperado).xlsx]682'!$L$8</c:f>
              <c:strCache>
                <c:ptCount val="1"/>
                <c:pt idx="0">
                  <c:v>PSi</c:v>
                </c:pt>
              </c:strCache>
            </c:strRef>
          </c:tx>
          <c:spPr>
            <a:solidFill>
              <a:schemeClr val="accent5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-1.2731334408019993E-17"/>
                  <c:y val="-4.1666666666666664E-2"/>
                </c:manualLayout>
              </c:layout>
              <c:tx>
                <c:rich>
                  <a:bodyPr/>
                  <a:lstStyle/>
                  <a:p>
                    <a:fld id="{BB53220F-3F9A-4D2C-B509-9440F490FF56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7-A908-4791-AE24-BEDADFD2AC1D}"/>
                </c:ext>
              </c:extLst>
            </c:dLbl>
            <c:dLbl>
              <c:idx val="1"/>
              <c:layout>
                <c:manualLayout>
                  <c:x val="0"/>
                  <c:y val="-4.6296296296296294E-2"/>
                </c:manualLayout>
              </c:layout>
              <c:tx>
                <c:rich>
                  <a:bodyPr/>
                  <a:lstStyle/>
                  <a:p>
                    <a:fld id="{E07AE3E9-02AC-4F7B-995B-857CB2016C41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8-A908-4791-AE24-BEDADFD2AC1D}"/>
                </c:ext>
              </c:extLst>
            </c:dLbl>
            <c:dLbl>
              <c:idx val="2"/>
              <c:layout>
                <c:manualLayout>
                  <c:x val="-5.5555555555555558E-3"/>
                  <c:y val="-0.17129629629629628"/>
                </c:manualLayout>
              </c:layout>
              <c:tx>
                <c:rich>
                  <a:bodyPr/>
                  <a:lstStyle/>
                  <a:p>
                    <a:fld id="{B8711DDA-7460-4029-B8DF-D87012CA7FA0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9-A908-4791-AE24-BEDADFD2AC1D}"/>
                </c:ext>
              </c:extLst>
            </c:dLbl>
            <c:dLbl>
              <c:idx val="3"/>
              <c:layout>
                <c:manualLayout>
                  <c:x val="0"/>
                  <c:y val="-1.388888888888888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A908-4791-AE24-BEDADFD2AC1D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r>
                      <a:rPr lang="en-US"/>
                      <a:t>ab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A908-4791-AE24-BEDADFD2AC1D}"/>
                </c:ext>
              </c:extLst>
            </c:dLbl>
            <c:dLbl>
              <c:idx val="5"/>
              <c:layout>
                <c:manualLayout>
                  <c:x val="-2.0370135052831988E-16"/>
                  <c:y val="-1.6975112544026657E-16"/>
                </c:manualLayout>
              </c:layout>
              <c:tx>
                <c:rich>
                  <a:bodyPr/>
                  <a:lstStyle/>
                  <a:p>
                    <a:fld id="{F05CF760-1DA5-40C4-A332-211EEC3E53CE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C-A908-4791-AE24-BEDADFD2AC1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en-US"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grafica%20185 (Recuperado).xlsx]682'!$L$10,'[grafica%20185 (Recuperado).xlsx]682'!$P$10,'[grafica%20185 (Recuperado).xlsx]682'!$T$10,'[grafica%20185 (Recuperado).xlsx]682'!$X$10,'[grafica%20185 (Recuperado).xlsx]682'!$AB$10,'[grafica%20185 (Recuperado).xlsx]682'!$AF$10</c:f>
                <c:numCache>
                  <c:formatCode>General</c:formatCode>
                  <c:ptCount val="6"/>
                  <c:pt idx="0">
                    <c:v>1.877283476097841</c:v>
                  </c:pt>
                  <c:pt idx="1">
                    <c:v>1.4564550196489823</c:v>
                  </c:pt>
                  <c:pt idx="2">
                    <c:v>5.8084702962748631</c:v>
                  </c:pt>
                  <c:pt idx="3">
                    <c:v>0.46333019851272195</c:v>
                  </c:pt>
                  <c:pt idx="4">
                    <c:v>0.17520278163237013</c:v>
                  </c:pt>
                  <c:pt idx="5">
                    <c:v>0.14878249096203408</c:v>
                  </c:pt>
                </c:numCache>
              </c:numRef>
            </c:plus>
            <c:minus>
              <c:numRef>
                <c:f>'[grafica%20185 (Recuperado).xlsx]682'!$L$10,'[grafica%20185 (Recuperado).xlsx]682'!$P$10,'[grafica%20185 (Recuperado).xlsx]682'!$T$10,'[grafica%20185 (Recuperado).xlsx]682'!$X$10,'[grafica%20185 (Recuperado).xlsx]682'!$AB$10,'[grafica%20185 (Recuperado).xlsx]682'!$AF$10</c:f>
                <c:numCache>
                  <c:formatCode>General</c:formatCode>
                  <c:ptCount val="6"/>
                  <c:pt idx="0">
                    <c:v>1.877283476097841</c:v>
                  </c:pt>
                  <c:pt idx="1">
                    <c:v>1.4564550196489823</c:v>
                  </c:pt>
                  <c:pt idx="2">
                    <c:v>5.8084702962748631</c:v>
                  </c:pt>
                  <c:pt idx="3">
                    <c:v>0.46333019851272195</c:v>
                  </c:pt>
                  <c:pt idx="4">
                    <c:v>0.17520278163237013</c:v>
                  </c:pt>
                  <c:pt idx="5">
                    <c:v>0.14878249096203408</c:v>
                  </c:pt>
                </c:numCache>
              </c:numRef>
            </c:minus>
          </c:errBars>
          <c:val>
            <c:numRef>
              <c:f>'[grafica%20185 (Recuperado).xlsx]682'!$L$9,'[grafica%20185 (Recuperado).xlsx]682'!$P$9,'[grafica%20185 (Recuperado).xlsx]682'!$T$9,'[grafica%20185 (Recuperado).xlsx]682'!$X$9,'[grafica%20185 (Recuperado).xlsx]682'!$AB$9,'[grafica%20185 (Recuperado).xlsx]682'!$AF$9</c:f>
              <c:numCache>
                <c:formatCode>General</c:formatCode>
                <c:ptCount val="6"/>
                <c:pt idx="0">
                  <c:v>8.2140144847559764</c:v>
                </c:pt>
                <c:pt idx="1">
                  <c:v>5.6215036297882079</c:v>
                </c:pt>
                <c:pt idx="2">
                  <c:v>11.439244632410832</c:v>
                </c:pt>
                <c:pt idx="3">
                  <c:v>2.647673242712417</c:v>
                </c:pt>
                <c:pt idx="4">
                  <c:v>1.3408267695637772</c:v>
                </c:pt>
                <c:pt idx="5">
                  <c:v>1.9228339743911695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grafica%20185 (Recuperado).xlsx]185'!$C$17:$H$17</c15:f>
                <c15:dlblRangeCache>
                  <c:ptCount val="6"/>
                  <c:pt idx="0">
                    <c:v>a</c:v>
                  </c:pt>
                  <c:pt idx="1">
                    <c:v>a</c:v>
                  </c:pt>
                  <c:pt idx="2">
                    <c:v>a</c:v>
                  </c:pt>
                  <c:pt idx="3">
                    <c:v>a</c:v>
                  </c:pt>
                  <c:pt idx="4">
                    <c:v>a</c:v>
                  </c:pt>
                  <c:pt idx="5">
                    <c:v>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D-A908-4791-AE24-BEDADFD2AC1D}"/>
            </c:ext>
          </c:extLst>
        </c:ser>
        <c:ser>
          <c:idx val="2"/>
          <c:order val="2"/>
          <c:tx>
            <c:strRef>
              <c:f>'[grafica%20185 (Recuperado).xlsx]682'!$N$8</c:f>
              <c:strCache>
                <c:ptCount val="1"/>
                <c:pt idx="0">
                  <c:v>PI 414723i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fld id="{AC52F89F-A09E-4C58-AEF4-A61737A2C963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E-A908-4791-AE24-BEDADFD2AC1D}"/>
                </c:ext>
              </c:extLst>
            </c:dLbl>
            <c:dLbl>
              <c:idx val="1"/>
              <c:layout>
                <c:manualLayout>
                  <c:x val="0"/>
                  <c:y val="-1.3888888888888888E-2"/>
                </c:manualLayout>
              </c:layout>
              <c:tx>
                <c:rich>
                  <a:bodyPr/>
                  <a:lstStyle/>
                  <a:p>
                    <a:fld id="{704015E5-08D2-4D25-9D12-43E4E6A61265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F-A908-4791-AE24-BEDADFD2AC1D}"/>
                </c:ext>
              </c:extLst>
            </c:dLbl>
            <c:dLbl>
              <c:idx val="2"/>
              <c:layout>
                <c:manualLayout>
                  <c:x val="2.7777777777777267E-3"/>
                  <c:y val="-5.092592592592584E-2"/>
                </c:manualLayout>
              </c:layout>
              <c:tx>
                <c:rich>
                  <a:bodyPr/>
                  <a:lstStyle/>
                  <a:p>
                    <a:fld id="{63EC3772-4489-4B27-AB0F-E921434A152F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0-A908-4791-AE24-BEDADFD2AC1D}"/>
                </c:ext>
              </c:extLst>
            </c:dLbl>
            <c:dLbl>
              <c:idx val="3"/>
              <c:layout>
                <c:manualLayout>
                  <c:x val="0"/>
                  <c:y val="-2.7777777777777776E-2"/>
                </c:manualLayout>
              </c:layout>
              <c:tx>
                <c:rich>
                  <a:bodyPr/>
                  <a:lstStyle/>
                  <a:p>
                    <a:fld id="{86B019B9-6152-40F1-978E-C1994D7BDD21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1-A908-4791-AE24-BEDADFD2AC1D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r>
                      <a:rPr lang="en-US"/>
                      <a:t>b</a:t>
                    </a: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2-A908-4791-AE24-BEDADFD2AC1D}"/>
                </c:ext>
              </c:extLst>
            </c:dLbl>
            <c:dLbl>
              <c:idx val="5"/>
              <c:layout>
                <c:manualLayout>
                  <c:x val="-1.0185067526415994E-16"/>
                  <c:y val="-2.3148148148148147E-2"/>
                </c:manualLayout>
              </c:layout>
              <c:tx>
                <c:rich>
                  <a:bodyPr/>
                  <a:lstStyle/>
                  <a:p>
                    <a:fld id="{E138EAC7-9CC8-4689-95D8-D921E9D5471B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3-A908-4791-AE24-BEDADFD2AC1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en-US"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dLblPos val="out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grafica%20185 (Recuperado).xlsx]682'!$M$10,'[grafica%20185 (Recuperado).xlsx]682'!$Q$10,'[grafica%20185 (Recuperado).xlsx]682'!$U$10,'[grafica%20185 (Recuperado).xlsx]682'!$Y$10,'[grafica%20185 (Recuperado).xlsx]682'!$AC$10,'[grafica%20185 (Recuperado).xlsx]682'!$AG$10</c:f>
                <c:numCache>
                  <c:formatCode>General</c:formatCode>
                  <c:ptCount val="6"/>
                  <c:pt idx="0">
                    <c:v>0.74108724292131078</c:v>
                  </c:pt>
                  <c:pt idx="1">
                    <c:v>0.56178331704905682</c:v>
                  </c:pt>
                  <c:pt idx="2">
                    <c:v>1.8362397883592669</c:v>
                  </c:pt>
                  <c:pt idx="3">
                    <c:v>0.67866758518611248</c:v>
                  </c:pt>
                  <c:pt idx="4">
                    <c:v>1.0687516187631814</c:v>
                  </c:pt>
                  <c:pt idx="5">
                    <c:v>1.4871865943725313</c:v>
                  </c:pt>
                </c:numCache>
              </c:numRef>
            </c:plus>
            <c:minus>
              <c:numRef>
                <c:f>'[grafica%20185 (Recuperado).xlsx]682'!$M$10,'[grafica%20185 (Recuperado).xlsx]682'!$Q$10,'[grafica%20185 (Recuperado).xlsx]682'!$U$10,'[grafica%20185 (Recuperado).xlsx]682'!$Y$10,'[grafica%20185 (Recuperado).xlsx]682'!$AC$10,'[grafica%20185 (Recuperado).xlsx]682'!$AG$10</c:f>
                <c:numCache>
                  <c:formatCode>General</c:formatCode>
                  <c:ptCount val="6"/>
                  <c:pt idx="0">
                    <c:v>0.74108724292131078</c:v>
                  </c:pt>
                  <c:pt idx="1">
                    <c:v>0.56178331704905682</c:v>
                  </c:pt>
                  <c:pt idx="2">
                    <c:v>1.8362397883592669</c:v>
                  </c:pt>
                  <c:pt idx="3">
                    <c:v>0.67866758518611248</c:v>
                  </c:pt>
                  <c:pt idx="4">
                    <c:v>1.0687516187631814</c:v>
                  </c:pt>
                  <c:pt idx="5">
                    <c:v>1.4871865943725313</c:v>
                  </c:pt>
                </c:numCache>
              </c:numRef>
            </c:minus>
          </c:errBars>
          <c:val>
            <c:numRef>
              <c:f>'[grafica%20185 (Recuperado).xlsx]682'!$M$9,'[grafica%20185 (Recuperado).xlsx]682'!$Q$9,'[grafica%20185 (Recuperado).xlsx]682'!$U$9,'[grafica%20185 (Recuperado).xlsx]682'!$Y$9,'[grafica%20185 (Recuperado).xlsx]682'!$AC$9,'[grafica%20185 (Recuperado).xlsx]682'!$AG$9</c:f>
              <c:numCache>
                <c:formatCode>General</c:formatCode>
                <c:ptCount val="6"/>
                <c:pt idx="0">
                  <c:v>4.3310231413609044</c:v>
                </c:pt>
                <c:pt idx="1">
                  <c:v>1.6656700116670657</c:v>
                </c:pt>
                <c:pt idx="2">
                  <c:v>1.8530249859844747</c:v>
                </c:pt>
                <c:pt idx="3">
                  <c:v>2.5569705710849333</c:v>
                </c:pt>
                <c:pt idx="4">
                  <c:v>5.5972270814910692</c:v>
                </c:pt>
                <c:pt idx="5">
                  <c:v>5.7139662650869623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grafica%20185 (Recuperado).xlsx]185'!$C$17:$H$17</c15:f>
                <c15:dlblRangeCache>
                  <c:ptCount val="6"/>
                  <c:pt idx="0">
                    <c:v>a</c:v>
                  </c:pt>
                  <c:pt idx="1">
                    <c:v>a</c:v>
                  </c:pt>
                  <c:pt idx="2">
                    <c:v>a</c:v>
                  </c:pt>
                  <c:pt idx="3">
                    <c:v>a</c:v>
                  </c:pt>
                  <c:pt idx="4">
                    <c:v>a</c:v>
                  </c:pt>
                  <c:pt idx="5">
                    <c:v>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14-A908-4791-AE24-BEDADFD2AC1D}"/>
            </c:ext>
          </c:extLst>
        </c:ser>
        <c:ser>
          <c:idx val="3"/>
          <c:order val="3"/>
          <c:tx>
            <c:strRef>
              <c:f>'[grafica%20185 (Recuperado).xlsx]682'!$M$8</c:f>
              <c:strCache>
                <c:ptCount val="1"/>
                <c:pt idx="0">
                  <c:v>PI414723m</c:v>
                </c:pt>
              </c:strCache>
            </c:strRef>
          </c:tx>
          <c:spPr>
            <a:solidFill>
              <a:srgbClr val="EB7525"/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4.1666666666666664E-2"/>
                </c:manualLayout>
              </c:layout>
              <c:tx>
                <c:rich>
                  <a:bodyPr/>
                  <a:lstStyle/>
                  <a:p>
                    <a:fld id="{350291F6-0DB7-43DB-B4A2-0D82A0A8CE76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5-A908-4791-AE24-BEDADFD2AC1D}"/>
                </c:ext>
              </c:extLst>
            </c:dLbl>
            <c:dLbl>
              <c:idx val="1"/>
              <c:layout>
                <c:manualLayout>
                  <c:x val="0"/>
                  <c:y val="-4.6296296296297144E-3"/>
                </c:manualLayout>
              </c:layout>
              <c:tx>
                <c:rich>
                  <a:bodyPr/>
                  <a:lstStyle/>
                  <a:p>
                    <a:fld id="{8D9792C3-9519-48F2-8FFE-25A383367010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6-A908-4791-AE24-BEDADFD2AC1D}"/>
                </c:ext>
              </c:extLst>
            </c:dLbl>
            <c:dLbl>
              <c:idx val="2"/>
              <c:layout>
                <c:manualLayout>
                  <c:x val="0"/>
                  <c:y val="-4.6296296296296384E-2"/>
                </c:manualLayout>
              </c:layout>
              <c:tx>
                <c:rich>
                  <a:bodyPr/>
                  <a:lstStyle/>
                  <a:p>
                    <a:fld id="{92852A7C-87D5-4BB2-BC45-17DA1838A2D4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7-A908-4791-AE24-BEDADFD2AC1D}"/>
                </c:ext>
              </c:extLst>
            </c:dLbl>
            <c:dLbl>
              <c:idx val="3"/>
              <c:layout>
                <c:manualLayout>
                  <c:x val="0"/>
                  <c:y val="-9.2592592592591737E-3"/>
                </c:manualLayout>
              </c:layout>
              <c:tx>
                <c:rich>
                  <a:bodyPr/>
                  <a:lstStyle/>
                  <a:p>
                    <a:fld id="{116FFCDE-1406-4E23-B5CF-91309FE41247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8-A908-4791-AE24-BEDADFD2AC1D}"/>
                </c:ext>
              </c:extLst>
            </c:dLbl>
            <c:dLbl>
              <c:idx val="4"/>
              <c:layout>
                <c:manualLayout>
                  <c:x val="0"/>
                  <c:y val="-2.7777777777777776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ab</a:t>
                    </a:r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9-A908-4791-AE24-BEDADFD2AC1D}"/>
                </c:ext>
              </c:extLst>
            </c:dLbl>
            <c:dLbl>
              <c:idx val="5"/>
              <c:layout>
                <c:manualLayout>
                  <c:x val="0"/>
                  <c:y val="-4.1666666666666664E-2"/>
                </c:manualLayout>
              </c:layout>
              <c:tx>
                <c:rich>
                  <a:bodyPr/>
                  <a:lstStyle/>
                  <a:p>
                    <a:fld id="{FBDA1C5C-CFFB-496E-B4AE-A6C6984A6F3C}" type="CELLRANGE">
                      <a:rPr lang="en-US"/>
                      <a:pPr/>
                      <a:t>[CELLRANGE]</a:t>
                    </a:fld>
                    <a:endParaRPr lang="es-E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A-A908-4791-AE24-BEDADFD2AC1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en-US"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grafica%20185 (Recuperado).xlsx]682'!$N$10,'[grafica%20185 (Recuperado).xlsx]682'!$R$10,'[grafica%20185 (Recuperado).xlsx]682'!$V$10,'[grafica%20185 (Recuperado).xlsx]682'!$Z$10,'[grafica%20185 (Recuperado).xlsx]682'!$AD$10,'[grafica%20185 (Recuperado).xlsx]682'!$AH$10</c:f>
                <c:numCache>
                  <c:formatCode>General</c:formatCode>
                  <c:ptCount val="6"/>
                  <c:pt idx="0">
                    <c:v>0.6044857177320232</c:v>
                  </c:pt>
                  <c:pt idx="1">
                    <c:v>0.47057799913175258</c:v>
                  </c:pt>
                  <c:pt idx="2">
                    <c:v>1.6739957139453292</c:v>
                  </c:pt>
                  <c:pt idx="3">
                    <c:v>0.31017287898640516</c:v>
                  </c:pt>
                  <c:pt idx="4">
                    <c:v>0.99832660036868903</c:v>
                  </c:pt>
                  <c:pt idx="5">
                    <c:v>1.7740152428496561</c:v>
                  </c:pt>
                </c:numCache>
              </c:numRef>
            </c:plus>
            <c:minus>
              <c:numRef>
                <c:f>'[grafica%20185 (Recuperado).xlsx]682'!$N$10,'[grafica%20185 (Recuperado).xlsx]682'!$R$10,'[grafica%20185 (Recuperado).xlsx]682'!$V$10,'[grafica%20185 (Recuperado).xlsx]682'!$Z$10,'[grafica%20185 (Recuperado).xlsx]682'!$AD$10,'[grafica%20185 (Recuperado).xlsx]682'!$AH$10</c:f>
                <c:numCache>
                  <c:formatCode>General</c:formatCode>
                  <c:ptCount val="6"/>
                  <c:pt idx="0">
                    <c:v>0.6044857177320232</c:v>
                  </c:pt>
                  <c:pt idx="1">
                    <c:v>0.47057799913175258</c:v>
                  </c:pt>
                  <c:pt idx="2">
                    <c:v>1.6739957139453292</c:v>
                  </c:pt>
                  <c:pt idx="3">
                    <c:v>0.31017287898640516</c:v>
                  </c:pt>
                  <c:pt idx="4">
                    <c:v>0.99832660036868903</c:v>
                  </c:pt>
                  <c:pt idx="5">
                    <c:v>1.7740152428496561</c:v>
                  </c:pt>
                </c:numCache>
              </c:numRef>
            </c:minus>
          </c:errBars>
          <c:val>
            <c:numRef>
              <c:f>'[grafica%20185 (Recuperado).xlsx]682'!$N$9,'[grafica%20185 (Recuperado).xlsx]682'!$R$9,'[grafica%20185 (Recuperado).xlsx]682'!$V$9,'[grafica%20185 (Recuperado).xlsx]682'!$Z$9,'[grafica%20185 (Recuperado).xlsx]682'!$AD$9,'[grafica%20185 (Recuperado).xlsx]682'!$AH$9</c:f>
              <c:numCache>
                <c:formatCode>General</c:formatCode>
                <c:ptCount val="6"/>
                <c:pt idx="0">
                  <c:v>3.4890098502550675</c:v>
                </c:pt>
                <c:pt idx="1">
                  <c:v>2.152889051411222</c:v>
                </c:pt>
                <c:pt idx="2">
                  <c:v>2.7899928565755525</c:v>
                </c:pt>
                <c:pt idx="3">
                  <c:v>1.8670793745504026</c:v>
                </c:pt>
                <c:pt idx="4">
                  <c:v>3.2212036957410675</c:v>
                </c:pt>
                <c:pt idx="5">
                  <c:v>4.333040094670821</c:v>
                </c:pt>
              </c:numCache>
            </c:numRef>
          </c:val>
          <c:extLst>
            <c:ext xmlns:c15="http://schemas.microsoft.com/office/drawing/2012/chart" uri="{02D57815-91ED-43cb-92C2-25804820EDAC}">
              <c15:datalabelsRange>
                <c15:f>'[grafica%20185 (Recuperado).xlsx]185'!$C$17:$H$17</c15:f>
                <c15:dlblRangeCache>
                  <c:ptCount val="6"/>
                  <c:pt idx="0">
                    <c:v>a</c:v>
                  </c:pt>
                  <c:pt idx="1">
                    <c:v>a</c:v>
                  </c:pt>
                  <c:pt idx="2">
                    <c:v>a</c:v>
                  </c:pt>
                  <c:pt idx="3">
                    <c:v>a</c:v>
                  </c:pt>
                  <c:pt idx="4">
                    <c:v>a</c:v>
                  </c:pt>
                  <c:pt idx="5">
                    <c:v>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1B-A908-4791-AE24-BEDADFD2AC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327016527"/>
        <c:axId val="1641995503"/>
      </c:barChart>
      <c:catAx>
        <c:axId val="132701652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641995503"/>
        <c:crosses val="autoZero"/>
        <c:auto val="1"/>
        <c:lblAlgn val="ctr"/>
        <c:lblOffset val="100"/>
        <c:noMultiLvlLbl val="0"/>
      </c:catAx>
      <c:valAx>
        <c:axId val="1641995503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327016527"/>
        <c:crosses val="autoZero"/>
        <c:crossBetween val="between"/>
      </c:valAx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en-US"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showDLblsOverMax val="0"/>
    <c:extLst/>
  </c:chart>
  <c:txPr>
    <a:bodyPr/>
    <a:lstStyle/>
    <a:p>
      <a:pPr>
        <a:defRPr lang="en-US" sz="900" b="0" i="0" u="none" strike="noStrike" kern="1200" baseline="0">
          <a:solidFill>
            <a:schemeClr val="tx1"/>
          </a:solidFill>
          <a:latin typeface="+mn-lt"/>
          <a:ea typeface="+mn-ea"/>
          <a:cs typeface="+mn-cs"/>
        </a:defRPr>
      </a:pPr>
      <a:endParaRPr lang="es-E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0BD502B-3C9B-DAA1-0B2B-41C5C7F98B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C0A40AFA-7B5A-BE79-CDBB-A23DDFCB3E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810C744-9DAB-9F3E-A93B-9545D50BA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EB1A0-7E67-4618-9F29-1857341FDB71}" type="datetimeFigureOut">
              <a:rPr lang="en-GB" smtClean="0"/>
              <a:t>26/07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BBEF0E3-D54E-6170-D556-3806DB475F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E53E9D4-21F7-783B-9505-067AD2E8E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0FDF4-4360-4266-92AF-C2CEB9FDF9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962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3F0D465-0570-992E-278E-40ED119E0C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34C3C08-859A-4C14-2CF4-6D001E03A2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6200E41-1BBB-780F-FBA2-B19400F344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EB1A0-7E67-4618-9F29-1857341FDB71}" type="datetimeFigureOut">
              <a:rPr lang="en-GB" smtClean="0"/>
              <a:t>26/07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2B97A72-73C3-E5AA-BD36-59369CB811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18A55E2-3898-FCBB-0B82-50C91B9206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0FDF4-4360-4266-92AF-C2CEB9FDF9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85216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730EFEE5-B0F2-441E-97B7-5652860243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599DC7E-B4E1-E3BB-C3EF-CBB951B008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B84A8CF-EDEB-BC2C-2377-FA076E336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EB1A0-7E67-4618-9F29-1857341FDB71}" type="datetimeFigureOut">
              <a:rPr lang="en-GB" smtClean="0"/>
              <a:t>26/07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B41DD2A-51F6-BB70-A50E-C936658C8E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D74BFAE-B57C-2C7F-A00E-5C390C71FF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0FDF4-4360-4266-92AF-C2CEB9FDF9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00125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C83225-5D83-57DA-08E5-FA1FB8B3A5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F25889F-5DD0-D702-3037-0EA1FDE3C0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9CB2531-DAB0-EA00-5761-244AAF98C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EB1A0-7E67-4618-9F29-1857341FDB71}" type="datetimeFigureOut">
              <a:rPr lang="en-GB" smtClean="0"/>
              <a:t>26/07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C117B8C-7B76-E67F-6A3D-D5D8112F47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999ADA3-5205-A81D-CEC6-164B8F58B8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0FDF4-4360-4266-92AF-C2CEB9FDF9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354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E1A0556-E211-20C6-B675-1888D816A5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59FA7A7-316C-442B-A065-CD2C3C6B34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5391215-F4BF-1590-BC40-748EC85D48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EB1A0-7E67-4618-9F29-1857341FDB71}" type="datetimeFigureOut">
              <a:rPr lang="en-GB" smtClean="0"/>
              <a:t>26/07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4A0BD50-E58F-D068-91EF-EA7B58A53C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B746ED2-BBD4-2FD6-5667-51F0D47BD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0FDF4-4360-4266-92AF-C2CEB9FDF9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7066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41B57ED-062C-7776-7522-D8B3CA94B1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1AB8290-D44F-5C2B-F8F9-C4A0F28DBD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7A00155-E9E7-1A65-EBD5-C64653B108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294C51F-263E-1113-8E46-59076F9B84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EB1A0-7E67-4618-9F29-1857341FDB71}" type="datetimeFigureOut">
              <a:rPr lang="en-GB" smtClean="0"/>
              <a:t>26/07/2024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9893A97-600B-4087-6646-441A72E20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247FD95-B5BC-7B05-7F6E-FD178F0162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0FDF4-4360-4266-92AF-C2CEB9FDF9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7795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ED259C9-866E-0520-D4E2-6A19F42955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310105A-D369-9E98-6F5B-B4533F2CFD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8495350-19B6-46A4-C211-C4F1E27E73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7E198C42-B08D-79E6-207B-AF0971F533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C3B1313C-9D37-3469-B8AB-5664A76A7E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381987D3-D810-7B01-A738-9B6A44DE2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EB1A0-7E67-4618-9F29-1857341FDB71}" type="datetimeFigureOut">
              <a:rPr lang="en-GB" smtClean="0"/>
              <a:t>26/07/2024</a:t>
            </a:fld>
            <a:endParaRPr lang="en-GB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31FC5967-F2C5-6638-AC7C-A5D295221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F165C4AF-3A92-CA21-98EB-D26E8EB7FE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0FDF4-4360-4266-92AF-C2CEB9FDF9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1900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F6C34E4-9492-2109-991D-5BA290AC0D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6FFB25AF-9A13-CD01-FBDD-C0529A61CB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EB1A0-7E67-4618-9F29-1857341FDB71}" type="datetimeFigureOut">
              <a:rPr lang="en-GB" smtClean="0"/>
              <a:t>26/07/2024</a:t>
            </a:fld>
            <a:endParaRPr lang="en-GB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7CFF9D8F-A6F1-74C4-FC1D-A6329E535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A37A3666-07DB-36D8-2715-ADF05B4BAB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0FDF4-4360-4266-92AF-C2CEB9FDF9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1568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782CDEFE-2E80-D1A7-C015-1C53A1F167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EB1A0-7E67-4618-9F29-1857341FDB71}" type="datetimeFigureOut">
              <a:rPr lang="en-GB" smtClean="0"/>
              <a:t>26/07/2024</a:t>
            </a:fld>
            <a:endParaRPr lang="en-GB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3C776E0F-A686-81EF-7671-24D4F9756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CCD02611-2283-C12E-E20D-1CD24D993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0FDF4-4360-4266-92AF-C2CEB9FDF9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8050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B3E0B73-ACE7-85B0-EE93-3EEE570F54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DABE2EC-83E2-B685-65CC-CBFAFBD0312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F58F421-BEEF-E16B-EC32-088ECFD9E9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EFC3416-2862-B9E6-CBCD-CD087EE967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EB1A0-7E67-4618-9F29-1857341FDB71}" type="datetimeFigureOut">
              <a:rPr lang="en-GB" smtClean="0"/>
              <a:t>26/07/2024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1796544-ACC2-D0EF-B1AC-DBB26F1AB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B1E2F9A-3C32-2FA5-988F-B1FF09D003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0FDF4-4360-4266-92AF-C2CEB9FDF9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93014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33CCCCD-B17D-C493-C93D-F85D07E5C0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410528BB-44CD-455F-31F5-70FAE39C29D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E5E6313-B63B-86FE-FE9E-E74A6ECE1B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948C8A2-DE98-4057-51EB-DDA026AF6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EB1A0-7E67-4618-9F29-1857341FDB71}" type="datetimeFigureOut">
              <a:rPr lang="en-GB" smtClean="0"/>
              <a:t>26/07/2024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3EC49AE-C6B9-6873-A58A-9D971C7323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C19EB80-AB6D-32C9-40D3-E5FA0C5C6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20FDF4-4360-4266-92AF-C2CEB9FDF9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9768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EAE4281F-760B-8806-5AEF-79F7E3832F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31FB415-9BC1-40A6-0BD1-303BDDB6C9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D581C02-DC73-5D0C-8055-E950D24781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2EB1A0-7E67-4618-9F29-1857341FDB71}" type="datetimeFigureOut">
              <a:rPr lang="en-GB" smtClean="0"/>
              <a:t>26/07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1580D8C-BCA5-DE4F-C62D-1E1C286A3A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CB5F705-844F-41EF-6460-C59D934819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20FDF4-4360-4266-92AF-C2CEB9FDF99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6374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áfico 4">
            <a:extLst>
              <a:ext uri="{FF2B5EF4-FFF2-40B4-BE49-F238E27FC236}">
                <a16:creationId xmlns:a16="http://schemas.microsoft.com/office/drawing/2014/main" id="{00000000-0008-0000-01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06160196"/>
              </p:ext>
            </p:extLst>
          </p:nvPr>
        </p:nvGraphicFramePr>
        <p:xfrm>
          <a:off x="6867525" y="107156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Gráfico 6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78126407"/>
              </p:ext>
            </p:extLst>
          </p:nvPr>
        </p:nvGraphicFramePr>
        <p:xfrm>
          <a:off x="752475" y="107156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Gráfico 8">
            <a:extLst>
              <a:ext uri="{FF2B5EF4-FFF2-40B4-BE49-F238E27FC236}">
                <a16:creationId xmlns:a16="http://schemas.microsoft.com/office/drawing/2014/main" id="{00000000-0008-0000-02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51695792"/>
              </p:ext>
            </p:extLst>
          </p:nvPr>
        </p:nvGraphicFramePr>
        <p:xfrm>
          <a:off x="752475" y="37719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CuadroTexto 10">
            <a:extLst>
              <a:ext uri="{FF2B5EF4-FFF2-40B4-BE49-F238E27FC236}">
                <a16:creationId xmlns:a16="http://schemas.microsoft.com/office/drawing/2014/main" id="{C8300960-C906-02CC-C43A-3F0B0E379FAA}"/>
              </a:ext>
            </a:extLst>
          </p:cNvPr>
          <p:cNvSpPr txBox="1"/>
          <p:nvPr/>
        </p:nvSpPr>
        <p:spPr>
          <a:xfrm>
            <a:off x="442913" y="114300"/>
            <a:ext cx="1099661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lative expression 2</a:t>
            </a:r>
            <a:r>
              <a:rPr lang="en-US" sz="1050" kern="1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−ΔΔCt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A) MELO3C017185.2, B) MELO3C017283.2, C) MELO3C017424.2, D) MELO3C029682.2, in plants inoculated with ToLCNDV (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Si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PI 414723i) and control plants (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Sm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PI 414723m, mock-inoculated) at 3, 6, 9, 15, 21 and 30 dpi. Bars represent standard error. Different letters in the same evaluation date indicate significant differences among genotypes (p &lt; 0.05, LSD test).</a:t>
            </a:r>
            <a:endParaRPr lang="en-GB" sz="1050" kern="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GB" sz="1050" dirty="0"/>
          </a:p>
        </p:txBody>
      </p:sp>
      <p:graphicFrame>
        <p:nvGraphicFramePr>
          <p:cNvPr id="12" name="Gráfico 11">
            <a:extLst>
              <a:ext uri="{FF2B5EF4-FFF2-40B4-BE49-F238E27FC236}">
                <a16:creationId xmlns:a16="http://schemas.microsoft.com/office/drawing/2014/main" id="{00000000-0008-0000-03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98895866"/>
              </p:ext>
            </p:extLst>
          </p:nvPr>
        </p:nvGraphicFramePr>
        <p:xfrm>
          <a:off x="6867525" y="37719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" name="CuadroTexto 12">
            <a:extLst>
              <a:ext uri="{FF2B5EF4-FFF2-40B4-BE49-F238E27FC236}">
                <a16:creationId xmlns:a16="http://schemas.microsoft.com/office/drawing/2014/main" id="{C8022573-6362-5F03-C1C1-66D12A7C3A0C}"/>
              </a:ext>
            </a:extLst>
          </p:cNvPr>
          <p:cNvSpPr txBox="1"/>
          <p:nvPr/>
        </p:nvSpPr>
        <p:spPr>
          <a:xfrm>
            <a:off x="752475" y="1071566"/>
            <a:ext cx="300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  <a:endParaRPr lang="en-GB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6C5D5B3F-E423-9F55-166D-E2C084DF4101}"/>
              </a:ext>
            </a:extLst>
          </p:cNvPr>
          <p:cNvSpPr txBox="1"/>
          <p:nvPr/>
        </p:nvSpPr>
        <p:spPr>
          <a:xfrm>
            <a:off x="6867525" y="1071566"/>
            <a:ext cx="300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  <a:endParaRPr lang="en-GB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83B90656-D507-D0D3-6A90-105BA1B47BFC}"/>
              </a:ext>
            </a:extLst>
          </p:cNvPr>
          <p:cNvSpPr txBox="1"/>
          <p:nvPr/>
        </p:nvSpPr>
        <p:spPr>
          <a:xfrm>
            <a:off x="752475" y="3813694"/>
            <a:ext cx="300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c</a:t>
            </a:r>
            <a:endParaRPr lang="en-GB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44AF1D52-33F2-9018-9E36-EE978F72257D}"/>
              </a:ext>
            </a:extLst>
          </p:cNvPr>
          <p:cNvSpPr txBox="1"/>
          <p:nvPr/>
        </p:nvSpPr>
        <p:spPr>
          <a:xfrm>
            <a:off x="6867525" y="3813694"/>
            <a:ext cx="300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d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528447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2</Words>
  <Application>Microsoft Office PowerPoint</Application>
  <PresentationFormat>Panorámica</PresentationFormat>
  <Paragraphs>8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ra Perez Moro</dc:creator>
  <cp:lastModifiedBy>Clara Perez Moro</cp:lastModifiedBy>
  <cp:revision>1</cp:revision>
  <dcterms:created xsi:type="dcterms:W3CDTF">2024-07-22T19:07:26Z</dcterms:created>
  <dcterms:modified xsi:type="dcterms:W3CDTF">2024-07-26T14:14:50Z</dcterms:modified>
</cp:coreProperties>
</file>